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6858000" cy="9906000" type="A4"/>
  <p:notesSz cx="6858000" cy="99456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伊藤 亮治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9522" autoAdjust="0"/>
  </p:normalViewPr>
  <p:slideViewPr>
    <p:cSldViewPr showGuides="1">
      <p:cViewPr>
        <p:scale>
          <a:sx n="121" d="100"/>
          <a:sy n="121" d="100"/>
        </p:scale>
        <p:origin x="-80" y="-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400" d="100"/>
        <a:sy n="4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AB841E-1F15-4F8C-AAE5-A53C36798B11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38363" y="746125"/>
            <a:ext cx="2581275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724202"/>
            <a:ext cx="5486400" cy="447556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B59CD2-5EFD-4A45-A8EB-99253E8F43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62155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90831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66566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5666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282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9979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6124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5584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5087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40809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4420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2398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1C14E-34D1-421B-823D-B334A10DB1AB}" type="datetimeFigureOut">
              <a:rPr kumimoji="1" lang="ja-JP" altLang="en-US" smtClean="0"/>
              <a:t>2017/04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FCFBA4-657A-4C66-92B4-70709DFFBFB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6759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png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png"/><Relationship Id="rId24" Type="http://schemas.openxmlformats.org/officeDocument/2006/relationships/image" Target="../media/image23.png"/><Relationship Id="rId25" Type="http://schemas.openxmlformats.org/officeDocument/2006/relationships/image" Target="../media/image24.png"/><Relationship Id="rId26" Type="http://schemas.openxmlformats.org/officeDocument/2006/relationships/image" Target="../media/image25.png"/><Relationship Id="rId27" Type="http://schemas.openxmlformats.org/officeDocument/2006/relationships/image" Target="../media/image26.png"/><Relationship Id="rId28" Type="http://schemas.openxmlformats.org/officeDocument/2006/relationships/image" Target="../media/image27.png"/><Relationship Id="rId29" Type="http://schemas.openxmlformats.org/officeDocument/2006/relationships/image" Target="../media/image28.png"/><Relationship Id="rId30" Type="http://schemas.openxmlformats.org/officeDocument/2006/relationships/image" Target="../media/image29.png"/><Relationship Id="rId31" Type="http://schemas.openxmlformats.org/officeDocument/2006/relationships/image" Target="../media/image30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8" name="Picture 6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96" t="9356" r="5796" b="20219"/>
          <a:stretch/>
        </p:blipFill>
        <p:spPr bwMode="auto">
          <a:xfrm>
            <a:off x="5030341" y="5434280"/>
            <a:ext cx="819864" cy="816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7" name="Picture 5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34" t="9356" r="5301" b="20219"/>
          <a:stretch/>
        </p:blipFill>
        <p:spPr bwMode="auto">
          <a:xfrm>
            <a:off x="5022470" y="4520952"/>
            <a:ext cx="830559" cy="816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40" name="Picture 11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96" t="9300" r="5796" b="19983"/>
          <a:stretch/>
        </p:blipFill>
        <p:spPr bwMode="auto">
          <a:xfrm>
            <a:off x="4130598" y="5429281"/>
            <a:ext cx="819864" cy="819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9" name="Picture 10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34" t="9300" r="5301" b="19983"/>
          <a:stretch/>
        </p:blipFill>
        <p:spPr bwMode="auto">
          <a:xfrm>
            <a:off x="4119903" y="4532638"/>
            <a:ext cx="830559" cy="8198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6" name="Picture 6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34" t="9577" r="5966" b="20009"/>
          <a:stretch/>
        </p:blipFill>
        <p:spPr bwMode="auto">
          <a:xfrm>
            <a:off x="3131500" y="5431482"/>
            <a:ext cx="810850" cy="8163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5" name="Picture 5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90" t="9577" r="5716" b="20009"/>
          <a:stretch/>
        </p:blipFill>
        <p:spPr bwMode="auto">
          <a:xfrm>
            <a:off x="3126003" y="4540883"/>
            <a:ext cx="816347" cy="8163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4" name="Picture 11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34" t="9621" r="5966" b="20201"/>
          <a:stretch/>
        </p:blipFill>
        <p:spPr bwMode="auto">
          <a:xfrm>
            <a:off x="2214158" y="5430706"/>
            <a:ext cx="810850" cy="8135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3" name="Picture 10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90" t="9621" r="5716" b="20201"/>
          <a:stretch/>
        </p:blipFill>
        <p:spPr bwMode="auto">
          <a:xfrm>
            <a:off x="2214158" y="4540815"/>
            <a:ext cx="816347" cy="8135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2" name="Picture 5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34" t="9129" r="5966" b="19745"/>
          <a:stretch/>
        </p:blipFill>
        <p:spPr bwMode="auto">
          <a:xfrm>
            <a:off x="1278054" y="5424551"/>
            <a:ext cx="810850" cy="8245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1" name="Picture 4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90" t="9129" r="5716" b="19745"/>
          <a:stretch/>
        </p:blipFill>
        <p:spPr bwMode="auto">
          <a:xfrm>
            <a:off x="1278054" y="4532638"/>
            <a:ext cx="816347" cy="8245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9" name="Picture 13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87" t="9506" r="5702" b="20070"/>
          <a:stretch/>
        </p:blipFill>
        <p:spPr bwMode="auto">
          <a:xfrm>
            <a:off x="5033219" y="2720752"/>
            <a:ext cx="823251" cy="816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8" name="Picture 12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3" t="9506" r="5620" b="20070"/>
          <a:stretch/>
        </p:blipFill>
        <p:spPr bwMode="auto">
          <a:xfrm>
            <a:off x="5030785" y="1820180"/>
            <a:ext cx="828121" cy="816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30" name="Picture 11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62" t="9506" r="5537" b="20070"/>
          <a:stretch/>
        </p:blipFill>
        <p:spPr bwMode="auto">
          <a:xfrm>
            <a:off x="5049204" y="951357"/>
            <a:ext cx="813086" cy="816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5" name="Picture 9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87" t="9517" r="5702" b="20058"/>
          <a:stretch/>
        </p:blipFill>
        <p:spPr bwMode="auto">
          <a:xfrm>
            <a:off x="4127211" y="2720752"/>
            <a:ext cx="823251" cy="816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3" name="Picture 8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33" t="9517" r="5620" b="20058"/>
          <a:stretch/>
        </p:blipFill>
        <p:spPr bwMode="auto">
          <a:xfrm>
            <a:off x="4122341" y="1813577"/>
            <a:ext cx="828121" cy="816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4" name="Picture 7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62" t="9517" r="5537" b="20058"/>
          <a:stretch/>
        </p:blipFill>
        <p:spPr bwMode="auto">
          <a:xfrm>
            <a:off x="4137376" y="952548"/>
            <a:ext cx="813086" cy="816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0" name="Picture 9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03" t="9218" r="5342" b="20064"/>
          <a:stretch/>
        </p:blipFill>
        <p:spPr bwMode="auto">
          <a:xfrm>
            <a:off x="3116381" y="2720752"/>
            <a:ext cx="825969" cy="8198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1" name="Picture 8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08" t="9218" r="5657" b="20064"/>
          <a:stretch/>
        </p:blipFill>
        <p:spPr bwMode="auto">
          <a:xfrm>
            <a:off x="3115480" y="1828906"/>
            <a:ext cx="826870" cy="8198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2" name="Picture 7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06" t="9218" r="4880" b="20064"/>
          <a:stretch/>
        </p:blipFill>
        <p:spPr bwMode="auto">
          <a:xfrm>
            <a:off x="3121899" y="941562"/>
            <a:ext cx="826638" cy="8198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9" name="Picture 5"/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03" t="9141" r="5342" b="20142"/>
          <a:stretch/>
        </p:blipFill>
        <p:spPr bwMode="auto">
          <a:xfrm>
            <a:off x="2201596" y="2720115"/>
            <a:ext cx="825969" cy="819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8" name="Picture 4"/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08" t="9140" r="5430" b="20141"/>
          <a:stretch/>
        </p:blipFill>
        <p:spPr bwMode="auto">
          <a:xfrm>
            <a:off x="2193174" y="1828880"/>
            <a:ext cx="829404" cy="8198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7" name="Picture 3"/>
          <p:cNvPicPr>
            <a:picLocks noChangeAspect="1" noChangeArrowheads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06" t="9140" r="4880" b="20141"/>
          <a:stretch/>
        </p:blipFill>
        <p:spPr bwMode="auto">
          <a:xfrm>
            <a:off x="2198165" y="944459"/>
            <a:ext cx="826638" cy="8198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6" name="Picture 5"/>
          <p:cNvPicPr>
            <a:picLocks noChangeAspect="1" noChangeArrowheads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03" t="9335" r="5342" b="19657"/>
          <a:stretch/>
        </p:blipFill>
        <p:spPr bwMode="auto">
          <a:xfrm>
            <a:off x="1267947" y="2720752"/>
            <a:ext cx="825969" cy="8232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5" name="Picture 4"/>
          <p:cNvPicPr>
            <a:picLocks noChangeAspect="1" noChangeArrowheads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08" t="9335" r="5657" b="19657"/>
          <a:stretch/>
        </p:blipFill>
        <p:spPr bwMode="auto">
          <a:xfrm>
            <a:off x="1267046" y="1825493"/>
            <a:ext cx="826870" cy="8232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4" name="Picture 3"/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06" t="9335" r="4880" b="19657"/>
          <a:stretch/>
        </p:blipFill>
        <p:spPr bwMode="auto">
          <a:xfrm>
            <a:off x="1278054" y="957093"/>
            <a:ext cx="826638" cy="8232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01" name="四角形吹き出し 500"/>
          <p:cNvSpPr/>
          <p:nvPr/>
        </p:nvSpPr>
        <p:spPr>
          <a:xfrm>
            <a:off x="2142150" y="403865"/>
            <a:ext cx="1873906" cy="5917287"/>
          </a:xfrm>
          <a:prstGeom prst="wedgeRectCallout">
            <a:avLst>
              <a:gd name="adj1" fmla="val 40111"/>
              <a:gd name="adj2" fmla="val 45623"/>
            </a:avLst>
          </a:prstGeom>
          <a:noFill/>
          <a:ln>
            <a:solidFill>
              <a:srgbClr val="000000"/>
            </a:solidFill>
            <a:prstDash val="dot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 dirty="0">
              <a:solidFill>
                <a:schemeClr val="tx1"/>
              </a:solidFill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6102590" y="1840593"/>
            <a:ext cx="475474" cy="276999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+mn-ea"/>
              </a:rPr>
              <a:t>CD4+</a:t>
            </a:r>
          </a:p>
          <a:p>
            <a:r>
              <a:rPr kumimoji="1" lang="en-US" altLang="ja-JP" sz="600" dirty="0" smtClean="0">
                <a:latin typeface="+mn-ea"/>
              </a:rPr>
              <a:t>Memory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6102590" y="2124504"/>
            <a:ext cx="475474" cy="276999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+mn-ea"/>
              </a:rPr>
              <a:t>CD8+</a:t>
            </a:r>
          </a:p>
          <a:p>
            <a:r>
              <a:rPr kumimoji="1" lang="en-US" altLang="ja-JP" sz="600" dirty="0" smtClean="0">
                <a:latin typeface="+mn-ea"/>
              </a:rPr>
              <a:t>Memory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6102590" y="2731785"/>
            <a:ext cx="392954" cy="276999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+mn-ea"/>
              </a:rPr>
              <a:t>CD4+</a:t>
            </a:r>
          </a:p>
          <a:p>
            <a:r>
              <a:rPr kumimoji="1" lang="en-US" altLang="ja-JP" sz="600" dirty="0" smtClean="0">
                <a:latin typeface="+mn-ea"/>
              </a:rPr>
              <a:t>Naive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6102590" y="3048344"/>
            <a:ext cx="392954" cy="276999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+mn-ea"/>
              </a:rPr>
              <a:t>CD8+</a:t>
            </a:r>
          </a:p>
          <a:p>
            <a:r>
              <a:rPr lang="en-US" altLang="ja-JP" sz="600" dirty="0" smtClean="0">
                <a:latin typeface="+mn-ea"/>
              </a:rPr>
              <a:t>Naïve</a:t>
            </a:r>
          </a:p>
        </p:txBody>
      </p:sp>
      <p:cxnSp>
        <p:nvCxnSpPr>
          <p:cNvPr id="69" name="直線コネクタ 68"/>
          <p:cNvCxnSpPr>
            <a:stCxn id="65" idx="1"/>
            <a:endCxn id="91" idx="4"/>
          </p:cNvCxnSpPr>
          <p:nvPr/>
        </p:nvCxnSpPr>
        <p:spPr>
          <a:xfrm flipH="1">
            <a:off x="5288119" y="1979093"/>
            <a:ext cx="814471" cy="79952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/>
          <p:cNvCxnSpPr>
            <a:stCxn id="66" idx="1"/>
          </p:cNvCxnSpPr>
          <p:nvPr/>
        </p:nvCxnSpPr>
        <p:spPr>
          <a:xfrm flipH="1">
            <a:off x="5603884" y="2263004"/>
            <a:ext cx="498706" cy="257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/>
          <p:cNvCxnSpPr>
            <a:stCxn id="67" idx="1"/>
            <a:endCxn id="93" idx="4"/>
          </p:cNvCxnSpPr>
          <p:nvPr/>
        </p:nvCxnSpPr>
        <p:spPr>
          <a:xfrm flipH="1">
            <a:off x="5248649" y="2870285"/>
            <a:ext cx="853941" cy="18867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/>
          <p:cNvCxnSpPr>
            <a:stCxn id="68" idx="1"/>
          </p:cNvCxnSpPr>
          <p:nvPr/>
        </p:nvCxnSpPr>
        <p:spPr>
          <a:xfrm flipH="1">
            <a:off x="5600594" y="3186844"/>
            <a:ext cx="501996" cy="159407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5" name="テキスト ボックス 544"/>
          <p:cNvSpPr txBox="1"/>
          <p:nvPr/>
        </p:nvSpPr>
        <p:spPr>
          <a:xfrm>
            <a:off x="6102590" y="4535673"/>
            <a:ext cx="447213" cy="184666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+mn-ea"/>
              </a:rPr>
              <a:t>Memory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546" name="テキスト ボックス 545"/>
          <p:cNvSpPr txBox="1"/>
          <p:nvPr/>
        </p:nvSpPr>
        <p:spPr>
          <a:xfrm>
            <a:off x="6102590" y="5021198"/>
            <a:ext cx="609862" cy="184666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 err="1" smtClean="0">
                <a:latin typeface="+mn-ea"/>
              </a:rPr>
              <a:t>Plasma</a:t>
            </a:r>
            <a:r>
              <a:rPr lang="en-US" altLang="ja-JP" sz="600" dirty="0" err="1" smtClean="0">
                <a:latin typeface="+mn-ea"/>
              </a:rPr>
              <a:t>blast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547" name="テキスト ボックス 546"/>
          <p:cNvSpPr txBox="1"/>
          <p:nvPr/>
        </p:nvSpPr>
        <p:spPr>
          <a:xfrm>
            <a:off x="6102590" y="5478504"/>
            <a:ext cx="570319" cy="184666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Transitiona</a:t>
            </a:r>
            <a:r>
              <a:rPr lang="en-US" altLang="ja-JP" sz="600" dirty="0">
                <a:latin typeface="+mn-ea"/>
              </a:rPr>
              <a:t>l</a:t>
            </a:r>
            <a:endParaRPr kumimoji="1" lang="en-US" altLang="ja-JP" sz="600" dirty="0" smtClean="0">
              <a:latin typeface="+mn-ea"/>
            </a:endParaRPr>
          </a:p>
        </p:txBody>
      </p:sp>
      <p:sp>
        <p:nvSpPr>
          <p:cNvPr id="548" name="テキスト ボックス 547"/>
          <p:cNvSpPr txBox="1"/>
          <p:nvPr/>
        </p:nvSpPr>
        <p:spPr>
          <a:xfrm>
            <a:off x="6102590" y="5739437"/>
            <a:ext cx="392954" cy="184666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Naïve</a:t>
            </a:r>
          </a:p>
        </p:txBody>
      </p:sp>
      <p:cxnSp>
        <p:nvCxnSpPr>
          <p:cNvPr id="549" name="直線コネクタ 548"/>
          <p:cNvCxnSpPr>
            <a:stCxn id="545" idx="1"/>
          </p:cNvCxnSpPr>
          <p:nvPr/>
        </p:nvCxnSpPr>
        <p:spPr>
          <a:xfrm flipH="1">
            <a:off x="5543214" y="4628006"/>
            <a:ext cx="559376" cy="178027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0" name="直線コネクタ 549"/>
          <p:cNvCxnSpPr>
            <a:stCxn id="546" idx="1"/>
          </p:cNvCxnSpPr>
          <p:nvPr/>
        </p:nvCxnSpPr>
        <p:spPr>
          <a:xfrm flipH="1">
            <a:off x="5850206" y="5113531"/>
            <a:ext cx="252384" cy="1206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1" name="直線コネクタ 550"/>
          <p:cNvCxnSpPr>
            <a:stCxn id="547" idx="1"/>
          </p:cNvCxnSpPr>
          <p:nvPr/>
        </p:nvCxnSpPr>
        <p:spPr>
          <a:xfrm flipH="1">
            <a:off x="5842334" y="5570837"/>
            <a:ext cx="260256" cy="7489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7" name="フリーフォーム 1026"/>
          <p:cNvSpPr/>
          <p:nvPr/>
        </p:nvSpPr>
        <p:spPr>
          <a:xfrm>
            <a:off x="1304909" y="960177"/>
            <a:ext cx="776758" cy="575408"/>
          </a:xfrm>
          <a:custGeom>
            <a:avLst/>
            <a:gdLst>
              <a:gd name="connsiteX0" fmla="*/ 0 w 397669"/>
              <a:gd name="connsiteY0" fmla="*/ 295275 h 295275"/>
              <a:gd name="connsiteX1" fmla="*/ 0 w 397669"/>
              <a:gd name="connsiteY1" fmla="*/ 0 h 295275"/>
              <a:gd name="connsiteX2" fmla="*/ 397669 w 397669"/>
              <a:gd name="connsiteY2" fmla="*/ 0 h 295275"/>
              <a:gd name="connsiteX3" fmla="*/ 397669 w 397669"/>
              <a:gd name="connsiteY3" fmla="*/ 76200 h 295275"/>
              <a:gd name="connsiteX4" fmla="*/ 0 w 397669"/>
              <a:gd name="connsiteY4" fmla="*/ 295275 h 295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7669" h="295275">
                <a:moveTo>
                  <a:pt x="0" y="295275"/>
                </a:moveTo>
                <a:lnTo>
                  <a:pt x="0" y="0"/>
                </a:lnTo>
                <a:lnTo>
                  <a:pt x="397669" y="0"/>
                </a:lnTo>
                <a:lnTo>
                  <a:pt x="397669" y="76200"/>
                </a:lnTo>
                <a:lnTo>
                  <a:pt x="0" y="295275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1028" name="フリーフォーム 1027"/>
          <p:cNvSpPr/>
          <p:nvPr/>
        </p:nvSpPr>
        <p:spPr>
          <a:xfrm>
            <a:off x="1304909" y="1113308"/>
            <a:ext cx="776757" cy="627993"/>
          </a:xfrm>
          <a:custGeom>
            <a:avLst/>
            <a:gdLst>
              <a:gd name="connsiteX0" fmla="*/ 0 w 390525"/>
              <a:gd name="connsiteY0" fmla="*/ 319087 h 319087"/>
              <a:gd name="connsiteX1" fmla="*/ 0 w 390525"/>
              <a:gd name="connsiteY1" fmla="*/ 216694 h 319087"/>
              <a:gd name="connsiteX2" fmla="*/ 390525 w 390525"/>
              <a:gd name="connsiteY2" fmla="*/ 0 h 319087"/>
              <a:gd name="connsiteX3" fmla="*/ 390525 w 390525"/>
              <a:gd name="connsiteY3" fmla="*/ 316706 h 319087"/>
              <a:gd name="connsiteX4" fmla="*/ 0 w 390525"/>
              <a:gd name="connsiteY4" fmla="*/ 319087 h 3190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0525" h="319087">
                <a:moveTo>
                  <a:pt x="0" y="319087"/>
                </a:moveTo>
                <a:lnTo>
                  <a:pt x="0" y="216694"/>
                </a:lnTo>
                <a:lnTo>
                  <a:pt x="390525" y="0"/>
                </a:lnTo>
                <a:lnTo>
                  <a:pt x="390525" y="316706"/>
                </a:lnTo>
                <a:lnTo>
                  <a:pt x="0" y="31908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432" name="テキスト ボックス 431"/>
          <p:cNvSpPr txBox="1"/>
          <p:nvPr/>
        </p:nvSpPr>
        <p:spPr>
          <a:xfrm>
            <a:off x="1782110" y="1538074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7.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31" name="テキスト ボックス 430"/>
          <p:cNvSpPr txBox="1"/>
          <p:nvPr/>
        </p:nvSpPr>
        <p:spPr>
          <a:xfrm>
            <a:off x="1239126" y="920552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 smtClean="0">
                <a:latin typeface="+mn-ea"/>
              </a:rPr>
              <a:t>53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029" name="フリーフォーム 1028"/>
          <p:cNvSpPr/>
          <p:nvPr/>
        </p:nvSpPr>
        <p:spPr>
          <a:xfrm>
            <a:off x="1307509" y="2008779"/>
            <a:ext cx="218099" cy="343388"/>
          </a:xfrm>
          <a:custGeom>
            <a:avLst/>
            <a:gdLst>
              <a:gd name="connsiteX0" fmla="*/ 7144 w 111919"/>
              <a:gd name="connsiteY0" fmla="*/ 176212 h 176212"/>
              <a:gd name="connsiteX1" fmla="*/ 0 w 111919"/>
              <a:gd name="connsiteY1" fmla="*/ 33337 h 176212"/>
              <a:gd name="connsiteX2" fmla="*/ 35719 w 111919"/>
              <a:gd name="connsiteY2" fmla="*/ 0 h 176212"/>
              <a:gd name="connsiteX3" fmla="*/ 107156 w 111919"/>
              <a:gd name="connsiteY3" fmla="*/ 28575 h 176212"/>
              <a:gd name="connsiteX4" fmla="*/ 111919 w 111919"/>
              <a:gd name="connsiteY4" fmla="*/ 104775 h 176212"/>
              <a:gd name="connsiteX5" fmla="*/ 7144 w 111919"/>
              <a:gd name="connsiteY5" fmla="*/ 176212 h 1762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11919" h="176212">
                <a:moveTo>
                  <a:pt x="7144" y="176212"/>
                </a:moveTo>
                <a:lnTo>
                  <a:pt x="0" y="33337"/>
                </a:lnTo>
                <a:lnTo>
                  <a:pt x="35719" y="0"/>
                </a:lnTo>
                <a:lnTo>
                  <a:pt x="107156" y="28575"/>
                </a:lnTo>
                <a:lnTo>
                  <a:pt x="111919" y="104775"/>
                </a:lnTo>
                <a:lnTo>
                  <a:pt x="7144" y="176212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1032" name="フリーフォーム 1031"/>
          <p:cNvSpPr/>
          <p:nvPr/>
        </p:nvSpPr>
        <p:spPr>
          <a:xfrm>
            <a:off x="1323171" y="2212370"/>
            <a:ext cx="515084" cy="403894"/>
          </a:xfrm>
          <a:custGeom>
            <a:avLst/>
            <a:gdLst>
              <a:gd name="connsiteX0" fmla="*/ 73819 w 264319"/>
              <a:gd name="connsiteY0" fmla="*/ 209550 h 209550"/>
              <a:gd name="connsiteX1" fmla="*/ 0 w 264319"/>
              <a:gd name="connsiteY1" fmla="*/ 76200 h 209550"/>
              <a:gd name="connsiteX2" fmla="*/ 107157 w 264319"/>
              <a:gd name="connsiteY2" fmla="*/ 0 h 209550"/>
              <a:gd name="connsiteX3" fmla="*/ 264319 w 264319"/>
              <a:gd name="connsiteY3" fmla="*/ 2381 h 209550"/>
              <a:gd name="connsiteX4" fmla="*/ 261938 w 264319"/>
              <a:gd name="connsiteY4" fmla="*/ 202406 h 209550"/>
              <a:gd name="connsiteX5" fmla="*/ 73819 w 264319"/>
              <a:gd name="connsiteY5" fmla="*/ 209550 h 2095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64319" h="209550">
                <a:moveTo>
                  <a:pt x="73819" y="209550"/>
                </a:moveTo>
                <a:lnTo>
                  <a:pt x="0" y="76200"/>
                </a:lnTo>
                <a:lnTo>
                  <a:pt x="107157" y="0"/>
                </a:lnTo>
                <a:lnTo>
                  <a:pt x="264319" y="2381"/>
                </a:lnTo>
                <a:cubicBezTo>
                  <a:pt x="263525" y="69056"/>
                  <a:pt x="262732" y="135731"/>
                  <a:pt x="261938" y="202406"/>
                </a:cubicBezTo>
                <a:lnTo>
                  <a:pt x="73819" y="20955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433" name="テキスト ボックス 432"/>
          <p:cNvSpPr txBox="1"/>
          <p:nvPr/>
        </p:nvSpPr>
        <p:spPr>
          <a:xfrm>
            <a:off x="1422070" y="1884000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2.</a:t>
            </a:r>
            <a:r>
              <a:rPr lang="en-US" altLang="ja-JP" sz="800" dirty="0">
                <a:latin typeface="+mn-ea"/>
              </a:rPr>
              <a:t>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34" name="テキスト ボックス 433"/>
          <p:cNvSpPr txBox="1"/>
          <p:nvPr/>
        </p:nvSpPr>
        <p:spPr>
          <a:xfrm>
            <a:off x="1765974" y="2288704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5.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035" name="フリーフォーム 1034"/>
          <p:cNvSpPr/>
          <p:nvPr/>
        </p:nvSpPr>
        <p:spPr>
          <a:xfrm>
            <a:off x="1299476" y="2931953"/>
            <a:ext cx="198822" cy="296985"/>
          </a:xfrm>
          <a:custGeom>
            <a:avLst/>
            <a:gdLst>
              <a:gd name="connsiteX0" fmla="*/ 28575 w 104775"/>
              <a:gd name="connsiteY0" fmla="*/ 152400 h 152400"/>
              <a:gd name="connsiteX1" fmla="*/ 0 w 104775"/>
              <a:gd name="connsiteY1" fmla="*/ 95250 h 152400"/>
              <a:gd name="connsiteX2" fmla="*/ 11906 w 104775"/>
              <a:gd name="connsiteY2" fmla="*/ 0 h 152400"/>
              <a:gd name="connsiteX3" fmla="*/ 104775 w 104775"/>
              <a:gd name="connsiteY3" fmla="*/ 4762 h 152400"/>
              <a:gd name="connsiteX4" fmla="*/ 90488 w 104775"/>
              <a:gd name="connsiteY4" fmla="*/ 102394 h 152400"/>
              <a:gd name="connsiteX5" fmla="*/ 28575 w 104775"/>
              <a:gd name="connsiteY5" fmla="*/ 152400 h 15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4775" h="152400">
                <a:moveTo>
                  <a:pt x="28575" y="152400"/>
                </a:moveTo>
                <a:lnTo>
                  <a:pt x="0" y="95250"/>
                </a:lnTo>
                <a:lnTo>
                  <a:pt x="11906" y="0"/>
                </a:lnTo>
                <a:lnTo>
                  <a:pt x="104775" y="4762"/>
                </a:lnTo>
                <a:lnTo>
                  <a:pt x="90488" y="102394"/>
                </a:lnTo>
                <a:lnTo>
                  <a:pt x="28575" y="152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1036" name="フリーフォーム 1035"/>
          <p:cNvSpPr/>
          <p:nvPr/>
        </p:nvSpPr>
        <p:spPr>
          <a:xfrm>
            <a:off x="1349569" y="3132377"/>
            <a:ext cx="487382" cy="365702"/>
          </a:xfrm>
          <a:custGeom>
            <a:avLst/>
            <a:gdLst>
              <a:gd name="connsiteX0" fmla="*/ 42863 w 242888"/>
              <a:gd name="connsiteY0" fmla="*/ 192881 h 192881"/>
              <a:gd name="connsiteX1" fmla="*/ 0 w 242888"/>
              <a:gd name="connsiteY1" fmla="*/ 52388 h 192881"/>
              <a:gd name="connsiteX2" fmla="*/ 59532 w 242888"/>
              <a:gd name="connsiteY2" fmla="*/ 2381 h 192881"/>
              <a:gd name="connsiteX3" fmla="*/ 242888 w 242888"/>
              <a:gd name="connsiteY3" fmla="*/ 0 h 192881"/>
              <a:gd name="connsiteX4" fmla="*/ 242888 w 242888"/>
              <a:gd name="connsiteY4" fmla="*/ 190500 h 192881"/>
              <a:gd name="connsiteX5" fmla="*/ 42863 w 242888"/>
              <a:gd name="connsiteY5" fmla="*/ 192881 h 1928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42888" h="192881">
                <a:moveTo>
                  <a:pt x="42863" y="192881"/>
                </a:moveTo>
                <a:lnTo>
                  <a:pt x="0" y="52388"/>
                </a:lnTo>
                <a:lnTo>
                  <a:pt x="59532" y="2381"/>
                </a:lnTo>
                <a:lnTo>
                  <a:pt x="242888" y="0"/>
                </a:lnTo>
                <a:lnTo>
                  <a:pt x="242888" y="190500"/>
                </a:lnTo>
                <a:lnTo>
                  <a:pt x="42863" y="19288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435" name="テキスト ボックス 434"/>
          <p:cNvSpPr txBox="1"/>
          <p:nvPr/>
        </p:nvSpPr>
        <p:spPr>
          <a:xfrm>
            <a:off x="1422070" y="2864768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8.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36" name="テキスト ボックス 435"/>
          <p:cNvSpPr txBox="1"/>
          <p:nvPr/>
        </p:nvSpPr>
        <p:spPr>
          <a:xfrm>
            <a:off x="1782110" y="3152800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0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21" name="フリーフォーム 120"/>
          <p:cNvSpPr/>
          <p:nvPr/>
        </p:nvSpPr>
        <p:spPr>
          <a:xfrm>
            <a:off x="2228789" y="956297"/>
            <a:ext cx="766966" cy="575407"/>
          </a:xfrm>
          <a:custGeom>
            <a:avLst/>
            <a:gdLst>
              <a:gd name="connsiteX0" fmla="*/ 0 w 397669"/>
              <a:gd name="connsiteY0" fmla="*/ 295275 h 295275"/>
              <a:gd name="connsiteX1" fmla="*/ 0 w 397669"/>
              <a:gd name="connsiteY1" fmla="*/ 0 h 295275"/>
              <a:gd name="connsiteX2" fmla="*/ 397669 w 397669"/>
              <a:gd name="connsiteY2" fmla="*/ 0 h 295275"/>
              <a:gd name="connsiteX3" fmla="*/ 397669 w 397669"/>
              <a:gd name="connsiteY3" fmla="*/ 76200 h 295275"/>
              <a:gd name="connsiteX4" fmla="*/ 0 w 397669"/>
              <a:gd name="connsiteY4" fmla="*/ 295275 h 295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7669" h="295275">
                <a:moveTo>
                  <a:pt x="0" y="295275"/>
                </a:moveTo>
                <a:lnTo>
                  <a:pt x="0" y="0"/>
                </a:lnTo>
                <a:lnTo>
                  <a:pt x="397669" y="0"/>
                </a:lnTo>
                <a:lnTo>
                  <a:pt x="397669" y="76200"/>
                </a:lnTo>
                <a:lnTo>
                  <a:pt x="0" y="295275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122" name="フリーフォーム 121"/>
          <p:cNvSpPr/>
          <p:nvPr/>
        </p:nvSpPr>
        <p:spPr>
          <a:xfrm>
            <a:off x="2228789" y="1109429"/>
            <a:ext cx="766966" cy="621810"/>
          </a:xfrm>
          <a:custGeom>
            <a:avLst/>
            <a:gdLst>
              <a:gd name="connsiteX0" fmla="*/ 0 w 390525"/>
              <a:gd name="connsiteY0" fmla="*/ 319087 h 319087"/>
              <a:gd name="connsiteX1" fmla="*/ 0 w 390525"/>
              <a:gd name="connsiteY1" fmla="*/ 216694 h 319087"/>
              <a:gd name="connsiteX2" fmla="*/ 390525 w 390525"/>
              <a:gd name="connsiteY2" fmla="*/ 0 h 319087"/>
              <a:gd name="connsiteX3" fmla="*/ 390525 w 390525"/>
              <a:gd name="connsiteY3" fmla="*/ 316706 h 319087"/>
              <a:gd name="connsiteX4" fmla="*/ 0 w 390525"/>
              <a:gd name="connsiteY4" fmla="*/ 319087 h 3190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0525" h="319087">
                <a:moveTo>
                  <a:pt x="0" y="319087"/>
                </a:moveTo>
                <a:lnTo>
                  <a:pt x="0" y="216694"/>
                </a:lnTo>
                <a:lnTo>
                  <a:pt x="390525" y="0"/>
                </a:lnTo>
                <a:lnTo>
                  <a:pt x="390525" y="316706"/>
                </a:lnTo>
                <a:lnTo>
                  <a:pt x="0" y="31908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439" name="テキスト ボックス 438"/>
          <p:cNvSpPr txBox="1"/>
          <p:nvPr/>
        </p:nvSpPr>
        <p:spPr>
          <a:xfrm>
            <a:off x="2158838" y="920552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8</a:t>
            </a:r>
            <a:r>
              <a:rPr kumimoji="1" lang="en-US" altLang="ja-JP" sz="800" dirty="0" smtClean="0">
                <a:latin typeface="+mn-ea"/>
              </a:rPr>
              <a:t>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40" name="テキスト ボックス 439"/>
          <p:cNvSpPr txBox="1"/>
          <p:nvPr/>
        </p:nvSpPr>
        <p:spPr>
          <a:xfrm>
            <a:off x="2662894" y="1538074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.3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23" name="フリーフォーム 122"/>
          <p:cNvSpPr/>
          <p:nvPr/>
        </p:nvSpPr>
        <p:spPr>
          <a:xfrm>
            <a:off x="2235819" y="2017492"/>
            <a:ext cx="214571" cy="343387"/>
          </a:xfrm>
          <a:custGeom>
            <a:avLst/>
            <a:gdLst>
              <a:gd name="connsiteX0" fmla="*/ 7144 w 111919"/>
              <a:gd name="connsiteY0" fmla="*/ 176212 h 176212"/>
              <a:gd name="connsiteX1" fmla="*/ 0 w 111919"/>
              <a:gd name="connsiteY1" fmla="*/ 33337 h 176212"/>
              <a:gd name="connsiteX2" fmla="*/ 35719 w 111919"/>
              <a:gd name="connsiteY2" fmla="*/ 0 h 176212"/>
              <a:gd name="connsiteX3" fmla="*/ 107156 w 111919"/>
              <a:gd name="connsiteY3" fmla="*/ 28575 h 176212"/>
              <a:gd name="connsiteX4" fmla="*/ 111919 w 111919"/>
              <a:gd name="connsiteY4" fmla="*/ 104775 h 176212"/>
              <a:gd name="connsiteX5" fmla="*/ 7144 w 111919"/>
              <a:gd name="connsiteY5" fmla="*/ 176212 h 1762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11919" h="176212">
                <a:moveTo>
                  <a:pt x="7144" y="176212"/>
                </a:moveTo>
                <a:lnTo>
                  <a:pt x="0" y="33337"/>
                </a:lnTo>
                <a:lnTo>
                  <a:pt x="35719" y="0"/>
                </a:lnTo>
                <a:lnTo>
                  <a:pt x="107156" y="28575"/>
                </a:lnTo>
                <a:lnTo>
                  <a:pt x="111919" y="104775"/>
                </a:lnTo>
                <a:lnTo>
                  <a:pt x="7144" y="176212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124" name="フリーフォーム 123"/>
          <p:cNvSpPr/>
          <p:nvPr/>
        </p:nvSpPr>
        <p:spPr>
          <a:xfrm>
            <a:off x="2251551" y="2212387"/>
            <a:ext cx="510843" cy="406963"/>
          </a:xfrm>
          <a:custGeom>
            <a:avLst/>
            <a:gdLst>
              <a:gd name="connsiteX0" fmla="*/ 73819 w 264319"/>
              <a:gd name="connsiteY0" fmla="*/ 209550 h 209550"/>
              <a:gd name="connsiteX1" fmla="*/ 0 w 264319"/>
              <a:gd name="connsiteY1" fmla="*/ 76200 h 209550"/>
              <a:gd name="connsiteX2" fmla="*/ 107157 w 264319"/>
              <a:gd name="connsiteY2" fmla="*/ 0 h 209550"/>
              <a:gd name="connsiteX3" fmla="*/ 264319 w 264319"/>
              <a:gd name="connsiteY3" fmla="*/ 2381 h 209550"/>
              <a:gd name="connsiteX4" fmla="*/ 261938 w 264319"/>
              <a:gd name="connsiteY4" fmla="*/ 202406 h 209550"/>
              <a:gd name="connsiteX5" fmla="*/ 73819 w 264319"/>
              <a:gd name="connsiteY5" fmla="*/ 209550 h 2095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64319" h="209550">
                <a:moveTo>
                  <a:pt x="73819" y="209550"/>
                </a:moveTo>
                <a:lnTo>
                  <a:pt x="0" y="76200"/>
                </a:lnTo>
                <a:lnTo>
                  <a:pt x="107157" y="0"/>
                </a:lnTo>
                <a:lnTo>
                  <a:pt x="264319" y="2381"/>
                </a:lnTo>
                <a:cubicBezTo>
                  <a:pt x="263525" y="69056"/>
                  <a:pt x="262732" y="135731"/>
                  <a:pt x="261938" y="202406"/>
                </a:cubicBezTo>
                <a:lnTo>
                  <a:pt x="73819" y="20955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441" name="テキスト ボックス 440"/>
          <p:cNvSpPr txBox="1"/>
          <p:nvPr/>
        </p:nvSpPr>
        <p:spPr>
          <a:xfrm>
            <a:off x="2358174" y="1884000"/>
            <a:ext cx="631386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0.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42" name="テキスト ボックス 441"/>
          <p:cNvSpPr txBox="1"/>
          <p:nvPr/>
        </p:nvSpPr>
        <p:spPr>
          <a:xfrm>
            <a:off x="2718214" y="2288704"/>
            <a:ext cx="631386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9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25" name="フリーフォーム 124"/>
          <p:cNvSpPr/>
          <p:nvPr/>
        </p:nvSpPr>
        <p:spPr>
          <a:xfrm>
            <a:off x="2236028" y="2942538"/>
            <a:ext cx="194154" cy="296985"/>
          </a:xfrm>
          <a:custGeom>
            <a:avLst/>
            <a:gdLst>
              <a:gd name="connsiteX0" fmla="*/ 28575 w 104775"/>
              <a:gd name="connsiteY0" fmla="*/ 152400 h 152400"/>
              <a:gd name="connsiteX1" fmla="*/ 0 w 104775"/>
              <a:gd name="connsiteY1" fmla="*/ 95250 h 152400"/>
              <a:gd name="connsiteX2" fmla="*/ 11906 w 104775"/>
              <a:gd name="connsiteY2" fmla="*/ 0 h 152400"/>
              <a:gd name="connsiteX3" fmla="*/ 104775 w 104775"/>
              <a:gd name="connsiteY3" fmla="*/ 4762 h 152400"/>
              <a:gd name="connsiteX4" fmla="*/ 90488 w 104775"/>
              <a:gd name="connsiteY4" fmla="*/ 102394 h 152400"/>
              <a:gd name="connsiteX5" fmla="*/ 28575 w 104775"/>
              <a:gd name="connsiteY5" fmla="*/ 152400 h 15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4775" h="152400">
                <a:moveTo>
                  <a:pt x="28575" y="152400"/>
                </a:moveTo>
                <a:lnTo>
                  <a:pt x="0" y="95250"/>
                </a:lnTo>
                <a:lnTo>
                  <a:pt x="11906" y="0"/>
                </a:lnTo>
                <a:lnTo>
                  <a:pt x="104775" y="4762"/>
                </a:lnTo>
                <a:lnTo>
                  <a:pt x="90488" y="102394"/>
                </a:lnTo>
                <a:lnTo>
                  <a:pt x="28575" y="152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126" name="フリーフォーム 125"/>
          <p:cNvSpPr/>
          <p:nvPr/>
        </p:nvSpPr>
        <p:spPr>
          <a:xfrm>
            <a:off x="2286166" y="3132794"/>
            <a:ext cx="473320" cy="375871"/>
          </a:xfrm>
          <a:custGeom>
            <a:avLst/>
            <a:gdLst>
              <a:gd name="connsiteX0" fmla="*/ 42863 w 242888"/>
              <a:gd name="connsiteY0" fmla="*/ 192881 h 192881"/>
              <a:gd name="connsiteX1" fmla="*/ 0 w 242888"/>
              <a:gd name="connsiteY1" fmla="*/ 52388 h 192881"/>
              <a:gd name="connsiteX2" fmla="*/ 59532 w 242888"/>
              <a:gd name="connsiteY2" fmla="*/ 2381 h 192881"/>
              <a:gd name="connsiteX3" fmla="*/ 242888 w 242888"/>
              <a:gd name="connsiteY3" fmla="*/ 0 h 192881"/>
              <a:gd name="connsiteX4" fmla="*/ 242888 w 242888"/>
              <a:gd name="connsiteY4" fmla="*/ 190500 h 192881"/>
              <a:gd name="connsiteX5" fmla="*/ 42863 w 242888"/>
              <a:gd name="connsiteY5" fmla="*/ 192881 h 1928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42888" h="192881">
                <a:moveTo>
                  <a:pt x="42863" y="192881"/>
                </a:moveTo>
                <a:lnTo>
                  <a:pt x="0" y="52388"/>
                </a:lnTo>
                <a:lnTo>
                  <a:pt x="59532" y="2381"/>
                </a:lnTo>
                <a:lnTo>
                  <a:pt x="242888" y="0"/>
                </a:lnTo>
                <a:lnTo>
                  <a:pt x="242888" y="190500"/>
                </a:lnTo>
                <a:lnTo>
                  <a:pt x="42863" y="19288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443" name="テキスト ボックス 442"/>
          <p:cNvSpPr txBox="1"/>
          <p:nvPr/>
        </p:nvSpPr>
        <p:spPr>
          <a:xfrm>
            <a:off x="2374862" y="2864768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9.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44" name="テキスト ボックス 443"/>
          <p:cNvSpPr txBox="1"/>
          <p:nvPr/>
        </p:nvSpPr>
        <p:spPr>
          <a:xfrm>
            <a:off x="2718214" y="3152800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7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33" name="フリーフォーム 132"/>
          <p:cNvSpPr/>
          <p:nvPr/>
        </p:nvSpPr>
        <p:spPr>
          <a:xfrm>
            <a:off x="3146441" y="957093"/>
            <a:ext cx="774944" cy="584674"/>
          </a:xfrm>
          <a:custGeom>
            <a:avLst/>
            <a:gdLst>
              <a:gd name="connsiteX0" fmla="*/ 0 w 397669"/>
              <a:gd name="connsiteY0" fmla="*/ 295275 h 295275"/>
              <a:gd name="connsiteX1" fmla="*/ 0 w 397669"/>
              <a:gd name="connsiteY1" fmla="*/ 0 h 295275"/>
              <a:gd name="connsiteX2" fmla="*/ 397669 w 397669"/>
              <a:gd name="connsiteY2" fmla="*/ 0 h 295275"/>
              <a:gd name="connsiteX3" fmla="*/ 397669 w 397669"/>
              <a:gd name="connsiteY3" fmla="*/ 76200 h 295275"/>
              <a:gd name="connsiteX4" fmla="*/ 0 w 397669"/>
              <a:gd name="connsiteY4" fmla="*/ 295275 h 295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7669" h="295275">
                <a:moveTo>
                  <a:pt x="0" y="295275"/>
                </a:moveTo>
                <a:lnTo>
                  <a:pt x="0" y="0"/>
                </a:lnTo>
                <a:lnTo>
                  <a:pt x="397669" y="0"/>
                </a:lnTo>
                <a:lnTo>
                  <a:pt x="397669" y="76200"/>
                </a:lnTo>
                <a:lnTo>
                  <a:pt x="0" y="295275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134" name="フリーフォーム 133"/>
          <p:cNvSpPr/>
          <p:nvPr/>
        </p:nvSpPr>
        <p:spPr>
          <a:xfrm>
            <a:off x="3146442" y="1119491"/>
            <a:ext cx="774944" cy="621811"/>
          </a:xfrm>
          <a:custGeom>
            <a:avLst/>
            <a:gdLst>
              <a:gd name="connsiteX0" fmla="*/ 0 w 390525"/>
              <a:gd name="connsiteY0" fmla="*/ 319087 h 319087"/>
              <a:gd name="connsiteX1" fmla="*/ 0 w 390525"/>
              <a:gd name="connsiteY1" fmla="*/ 216694 h 319087"/>
              <a:gd name="connsiteX2" fmla="*/ 390525 w 390525"/>
              <a:gd name="connsiteY2" fmla="*/ 0 h 319087"/>
              <a:gd name="connsiteX3" fmla="*/ 390525 w 390525"/>
              <a:gd name="connsiteY3" fmla="*/ 316706 h 319087"/>
              <a:gd name="connsiteX4" fmla="*/ 0 w 390525"/>
              <a:gd name="connsiteY4" fmla="*/ 319087 h 3190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0525" h="319087">
                <a:moveTo>
                  <a:pt x="0" y="319087"/>
                </a:moveTo>
                <a:lnTo>
                  <a:pt x="0" y="216694"/>
                </a:lnTo>
                <a:lnTo>
                  <a:pt x="390525" y="0"/>
                </a:lnTo>
                <a:lnTo>
                  <a:pt x="390525" y="316706"/>
                </a:lnTo>
                <a:lnTo>
                  <a:pt x="0" y="31908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447" name="テキスト ボックス 446"/>
          <p:cNvSpPr txBox="1"/>
          <p:nvPr/>
        </p:nvSpPr>
        <p:spPr>
          <a:xfrm>
            <a:off x="3078254" y="920552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2</a:t>
            </a:r>
            <a:r>
              <a:rPr kumimoji="1" lang="en-US" altLang="ja-JP" sz="800" dirty="0" smtClean="0">
                <a:latin typeface="+mn-ea"/>
              </a:rPr>
              <a:t>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48" name="テキスト ボックス 447"/>
          <p:cNvSpPr txBox="1"/>
          <p:nvPr/>
        </p:nvSpPr>
        <p:spPr>
          <a:xfrm>
            <a:off x="3598998" y="1538074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.0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043" name="フリーフォーム 1042"/>
          <p:cNvSpPr/>
          <p:nvPr/>
        </p:nvSpPr>
        <p:spPr>
          <a:xfrm>
            <a:off x="3149913" y="2018405"/>
            <a:ext cx="199688" cy="457093"/>
          </a:xfrm>
          <a:custGeom>
            <a:avLst/>
            <a:gdLst>
              <a:gd name="connsiteX0" fmla="*/ 38100 w 102394"/>
              <a:gd name="connsiteY0" fmla="*/ 242888 h 242888"/>
              <a:gd name="connsiteX1" fmla="*/ 0 w 102394"/>
              <a:gd name="connsiteY1" fmla="*/ 140494 h 242888"/>
              <a:gd name="connsiteX2" fmla="*/ 2381 w 102394"/>
              <a:gd name="connsiteY2" fmla="*/ 21431 h 242888"/>
              <a:gd name="connsiteX3" fmla="*/ 64294 w 102394"/>
              <a:gd name="connsiteY3" fmla="*/ 0 h 242888"/>
              <a:gd name="connsiteX4" fmla="*/ 102394 w 102394"/>
              <a:gd name="connsiteY4" fmla="*/ 38100 h 242888"/>
              <a:gd name="connsiteX5" fmla="*/ 102394 w 102394"/>
              <a:gd name="connsiteY5" fmla="*/ 116681 h 242888"/>
              <a:gd name="connsiteX6" fmla="*/ 38100 w 102394"/>
              <a:gd name="connsiteY6" fmla="*/ 242888 h 2428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102394" h="242888">
                <a:moveTo>
                  <a:pt x="38100" y="242888"/>
                </a:moveTo>
                <a:lnTo>
                  <a:pt x="0" y="140494"/>
                </a:lnTo>
                <a:cubicBezTo>
                  <a:pt x="794" y="100806"/>
                  <a:pt x="1587" y="61119"/>
                  <a:pt x="2381" y="21431"/>
                </a:cubicBezTo>
                <a:lnTo>
                  <a:pt x="64294" y="0"/>
                </a:lnTo>
                <a:lnTo>
                  <a:pt x="102394" y="38100"/>
                </a:lnTo>
                <a:lnTo>
                  <a:pt x="102394" y="116681"/>
                </a:lnTo>
                <a:lnTo>
                  <a:pt x="38100" y="242888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1044" name="フリーフォーム 1043"/>
          <p:cNvSpPr/>
          <p:nvPr/>
        </p:nvSpPr>
        <p:spPr>
          <a:xfrm>
            <a:off x="3224399" y="2126610"/>
            <a:ext cx="454757" cy="489575"/>
          </a:xfrm>
          <a:custGeom>
            <a:avLst/>
            <a:gdLst>
              <a:gd name="connsiteX0" fmla="*/ 45243 w 233362"/>
              <a:gd name="connsiteY0" fmla="*/ 259556 h 259556"/>
              <a:gd name="connsiteX1" fmla="*/ 0 w 233362"/>
              <a:gd name="connsiteY1" fmla="*/ 188119 h 259556"/>
              <a:gd name="connsiteX2" fmla="*/ 71437 w 233362"/>
              <a:gd name="connsiteY2" fmla="*/ 42863 h 259556"/>
              <a:gd name="connsiteX3" fmla="*/ 128587 w 233362"/>
              <a:gd name="connsiteY3" fmla="*/ 0 h 259556"/>
              <a:gd name="connsiteX4" fmla="*/ 233362 w 233362"/>
              <a:gd name="connsiteY4" fmla="*/ 52388 h 259556"/>
              <a:gd name="connsiteX5" fmla="*/ 230981 w 233362"/>
              <a:gd name="connsiteY5" fmla="*/ 259556 h 259556"/>
              <a:gd name="connsiteX6" fmla="*/ 45243 w 233362"/>
              <a:gd name="connsiteY6" fmla="*/ 259556 h 2595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33362" h="259556">
                <a:moveTo>
                  <a:pt x="45243" y="259556"/>
                </a:moveTo>
                <a:lnTo>
                  <a:pt x="0" y="188119"/>
                </a:lnTo>
                <a:lnTo>
                  <a:pt x="71437" y="42863"/>
                </a:lnTo>
                <a:lnTo>
                  <a:pt x="128587" y="0"/>
                </a:lnTo>
                <a:lnTo>
                  <a:pt x="233362" y="52388"/>
                </a:lnTo>
                <a:cubicBezTo>
                  <a:pt x="232568" y="121444"/>
                  <a:pt x="231775" y="190500"/>
                  <a:pt x="230981" y="259556"/>
                </a:cubicBezTo>
                <a:lnTo>
                  <a:pt x="45243" y="259556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449" name="テキスト ボックス 448"/>
          <p:cNvSpPr txBox="1"/>
          <p:nvPr/>
        </p:nvSpPr>
        <p:spPr>
          <a:xfrm>
            <a:off x="3238957" y="1884000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2.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50" name="テキスト ボックス 449"/>
          <p:cNvSpPr txBox="1"/>
          <p:nvPr/>
        </p:nvSpPr>
        <p:spPr>
          <a:xfrm>
            <a:off x="3654318" y="2288704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6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045" name="フリーフォーム 1044"/>
          <p:cNvSpPr/>
          <p:nvPr/>
        </p:nvSpPr>
        <p:spPr>
          <a:xfrm>
            <a:off x="3151402" y="2962617"/>
            <a:ext cx="176335" cy="389792"/>
          </a:xfrm>
          <a:custGeom>
            <a:avLst/>
            <a:gdLst>
              <a:gd name="connsiteX0" fmla="*/ 30956 w 90488"/>
              <a:gd name="connsiteY0" fmla="*/ 200025 h 200025"/>
              <a:gd name="connsiteX1" fmla="*/ 0 w 90488"/>
              <a:gd name="connsiteY1" fmla="*/ 104775 h 200025"/>
              <a:gd name="connsiteX2" fmla="*/ 0 w 90488"/>
              <a:gd name="connsiteY2" fmla="*/ 54769 h 200025"/>
              <a:gd name="connsiteX3" fmla="*/ 45244 w 90488"/>
              <a:gd name="connsiteY3" fmla="*/ 0 h 200025"/>
              <a:gd name="connsiteX4" fmla="*/ 88106 w 90488"/>
              <a:gd name="connsiteY4" fmla="*/ 52388 h 200025"/>
              <a:gd name="connsiteX5" fmla="*/ 90488 w 90488"/>
              <a:gd name="connsiteY5" fmla="*/ 90488 h 200025"/>
              <a:gd name="connsiteX6" fmla="*/ 30956 w 90488"/>
              <a:gd name="connsiteY6" fmla="*/ 200025 h 2000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90488" h="200025">
                <a:moveTo>
                  <a:pt x="30956" y="200025"/>
                </a:moveTo>
                <a:lnTo>
                  <a:pt x="0" y="104775"/>
                </a:lnTo>
                <a:lnTo>
                  <a:pt x="0" y="54769"/>
                </a:lnTo>
                <a:lnTo>
                  <a:pt x="45244" y="0"/>
                </a:lnTo>
                <a:lnTo>
                  <a:pt x="88106" y="52388"/>
                </a:lnTo>
                <a:lnTo>
                  <a:pt x="90488" y="90488"/>
                </a:lnTo>
                <a:lnTo>
                  <a:pt x="30956" y="200025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1047" name="フリーフォーム 1046"/>
          <p:cNvSpPr/>
          <p:nvPr/>
        </p:nvSpPr>
        <p:spPr>
          <a:xfrm>
            <a:off x="3216368" y="3035347"/>
            <a:ext cx="464038" cy="473318"/>
          </a:xfrm>
          <a:custGeom>
            <a:avLst/>
            <a:gdLst>
              <a:gd name="connsiteX0" fmla="*/ 35718 w 238125"/>
              <a:gd name="connsiteY0" fmla="*/ 242887 h 242887"/>
              <a:gd name="connsiteX1" fmla="*/ 0 w 238125"/>
              <a:gd name="connsiteY1" fmla="*/ 161925 h 242887"/>
              <a:gd name="connsiteX2" fmla="*/ 66675 w 238125"/>
              <a:gd name="connsiteY2" fmla="*/ 45243 h 242887"/>
              <a:gd name="connsiteX3" fmla="*/ 116681 w 238125"/>
              <a:gd name="connsiteY3" fmla="*/ 0 h 242887"/>
              <a:gd name="connsiteX4" fmla="*/ 238125 w 238125"/>
              <a:gd name="connsiteY4" fmla="*/ 59531 h 242887"/>
              <a:gd name="connsiteX5" fmla="*/ 238125 w 238125"/>
              <a:gd name="connsiteY5" fmla="*/ 240506 h 242887"/>
              <a:gd name="connsiteX6" fmla="*/ 35718 w 238125"/>
              <a:gd name="connsiteY6" fmla="*/ 242887 h 2428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38125" h="242887">
                <a:moveTo>
                  <a:pt x="35718" y="242887"/>
                </a:moveTo>
                <a:lnTo>
                  <a:pt x="0" y="161925"/>
                </a:lnTo>
                <a:lnTo>
                  <a:pt x="66675" y="45243"/>
                </a:lnTo>
                <a:lnTo>
                  <a:pt x="116681" y="0"/>
                </a:lnTo>
                <a:lnTo>
                  <a:pt x="238125" y="59531"/>
                </a:lnTo>
                <a:lnTo>
                  <a:pt x="238125" y="240506"/>
                </a:lnTo>
                <a:lnTo>
                  <a:pt x="35718" y="24288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>
              <a:latin typeface="+mn-ea"/>
            </a:endParaRPr>
          </a:p>
        </p:txBody>
      </p:sp>
      <p:sp>
        <p:nvSpPr>
          <p:cNvPr id="451" name="テキスト ボックス 450"/>
          <p:cNvSpPr txBox="1"/>
          <p:nvPr/>
        </p:nvSpPr>
        <p:spPr>
          <a:xfrm>
            <a:off x="3238958" y="2864768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6.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452" name="テキスト ボックス 451"/>
          <p:cNvSpPr txBox="1"/>
          <p:nvPr/>
        </p:nvSpPr>
        <p:spPr>
          <a:xfrm>
            <a:off x="3654318" y="3152800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1.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84" name="フリーフォーム 283"/>
          <p:cNvSpPr/>
          <p:nvPr/>
        </p:nvSpPr>
        <p:spPr>
          <a:xfrm>
            <a:off x="4167598" y="2013016"/>
            <a:ext cx="218098" cy="343387"/>
          </a:xfrm>
          <a:custGeom>
            <a:avLst/>
            <a:gdLst>
              <a:gd name="connsiteX0" fmla="*/ 7144 w 111919"/>
              <a:gd name="connsiteY0" fmla="*/ 176212 h 176212"/>
              <a:gd name="connsiteX1" fmla="*/ 0 w 111919"/>
              <a:gd name="connsiteY1" fmla="*/ 33337 h 176212"/>
              <a:gd name="connsiteX2" fmla="*/ 35719 w 111919"/>
              <a:gd name="connsiteY2" fmla="*/ 0 h 176212"/>
              <a:gd name="connsiteX3" fmla="*/ 107156 w 111919"/>
              <a:gd name="connsiteY3" fmla="*/ 28575 h 176212"/>
              <a:gd name="connsiteX4" fmla="*/ 111919 w 111919"/>
              <a:gd name="connsiteY4" fmla="*/ 104775 h 176212"/>
              <a:gd name="connsiteX5" fmla="*/ 7144 w 111919"/>
              <a:gd name="connsiteY5" fmla="*/ 176212 h 1762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11919" h="176212">
                <a:moveTo>
                  <a:pt x="7144" y="176212"/>
                </a:moveTo>
                <a:lnTo>
                  <a:pt x="0" y="33337"/>
                </a:lnTo>
                <a:lnTo>
                  <a:pt x="35719" y="0"/>
                </a:lnTo>
                <a:lnTo>
                  <a:pt x="107156" y="28575"/>
                </a:lnTo>
                <a:lnTo>
                  <a:pt x="111919" y="104775"/>
                </a:lnTo>
                <a:lnTo>
                  <a:pt x="7144" y="176212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285" name="フリーフォーム 284"/>
          <p:cNvSpPr/>
          <p:nvPr/>
        </p:nvSpPr>
        <p:spPr>
          <a:xfrm>
            <a:off x="4176878" y="2207912"/>
            <a:ext cx="515083" cy="387182"/>
          </a:xfrm>
          <a:custGeom>
            <a:avLst/>
            <a:gdLst>
              <a:gd name="connsiteX0" fmla="*/ 73819 w 264319"/>
              <a:gd name="connsiteY0" fmla="*/ 209550 h 209550"/>
              <a:gd name="connsiteX1" fmla="*/ 0 w 264319"/>
              <a:gd name="connsiteY1" fmla="*/ 76200 h 209550"/>
              <a:gd name="connsiteX2" fmla="*/ 107157 w 264319"/>
              <a:gd name="connsiteY2" fmla="*/ 0 h 209550"/>
              <a:gd name="connsiteX3" fmla="*/ 264319 w 264319"/>
              <a:gd name="connsiteY3" fmla="*/ 2381 h 209550"/>
              <a:gd name="connsiteX4" fmla="*/ 261938 w 264319"/>
              <a:gd name="connsiteY4" fmla="*/ 202406 h 209550"/>
              <a:gd name="connsiteX5" fmla="*/ 73819 w 264319"/>
              <a:gd name="connsiteY5" fmla="*/ 209550 h 2095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64319" h="209550">
                <a:moveTo>
                  <a:pt x="73819" y="209550"/>
                </a:moveTo>
                <a:lnTo>
                  <a:pt x="0" y="76200"/>
                </a:lnTo>
                <a:lnTo>
                  <a:pt x="107157" y="0"/>
                </a:lnTo>
                <a:lnTo>
                  <a:pt x="264319" y="2381"/>
                </a:lnTo>
                <a:cubicBezTo>
                  <a:pt x="263525" y="69056"/>
                  <a:pt x="262732" y="135731"/>
                  <a:pt x="261938" y="202406"/>
                </a:cubicBezTo>
                <a:lnTo>
                  <a:pt x="73819" y="20955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585" name="テキスト ボックス 584"/>
          <p:cNvSpPr txBox="1"/>
          <p:nvPr/>
        </p:nvSpPr>
        <p:spPr>
          <a:xfrm>
            <a:off x="4662430" y="2288704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2.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86" name="フリーフォーム 285"/>
          <p:cNvSpPr/>
          <p:nvPr/>
        </p:nvSpPr>
        <p:spPr>
          <a:xfrm>
            <a:off x="4158374" y="2939792"/>
            <a:ext cx="204177" cy="296984"/>
          </a:xfrm>
          <a:custGeom>
            <a:avLst/>
            <a:gdLst>
              <a:gd name="connsiteX0" fmla="*/ 28575 w 104775"/>
              <a:gd name="connsiteY0" fmla="*/ 152400 h 152400"/>
              <a:gd name="connsiteX1" fmla="*/ 0 w 104775"/>
              <a:gd name="connsiteY1" fmla="*/ 95250 h 152400"/>
              <a:gd name="connsiteX2" fmla="*/ 11906 w 104775"/>
              <a:gd name="connsiteY2" fmla="*/ 0 h 152400"/>
              <a:gd name="connsiteX3" fmla="*/ 104775 w 104775"/>
              <a:gd name="connsiteY3" fmla="*/ 4762 h 152400"/>
              <a:gd name="connsiteX4" fmla="*/ 90488 w 104775"/>
              <a:gd name="connsiteY4" fmla="*/ 102394 h 152400"/>
              <a:gd name="connsiteX5" fmla="*/ 28575 w 104775"/>
              <a:gd name="connsiteY5" fmla="*/ 152400 h 152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4775" h="152400">
                <a:moveTo>
                  <a:pt x="28575" y="152400"/>
                </a:moveTo>
                <a:lnTo>
                  <a:pt x="0" y="95250"/>
                </a:lnTo>
                <a:lnTo>
                  <a:pt x="11906" y="0"/>
                </a:lnTo>
                <a:lnTo>
                  <a:pt x="104775" y="4762"/>
                </a:lnTo>
                <a:lnTo>
                  <a:pt x="90488" y="102394"/>
                </a:lnTo>
                <a:lnTo>
                  <a:pt x="28575" y="152400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287" name="フリーフォーム 286"/>
          <p:cNvSpPr/>
          <p:nvPr/>
        </p:nvSpPr>
        <p:spPr>
          <a:xfrm>
            <a:off x="4218699" y="3130047"/>
            <a:ext cx="473320" cy="375870"/>
          </a:xfrm>
          <a:custGeom>
            <a:avLst/>
            <a:gdLst>
              <a:gd name="connsiteX0" fmla="*/ 42863 w 242888"/>
              <a:gd name="connsiteY0" fmla="*/ 192881 h 192881"/>
              <a:gd name="connsiteX1" fmla="*/ 0 w 242888"/>
              <a:gd name="connsiteY1" fmla="*/ 52388 h 192881"/>
              <a:gd name="connsiteX2" fmla="*/ 59532 w 242888"/>
              <a:gd name="connsiteY2" fmla="*/ 2381 h 192881"/>
              <a:gd name="connsiteX3" fmla="*/ 242888 w 242888"/>
              <a:gd name="connsiteY3" fmla="*/ 0 h 192881"/>
              <a:gd name="connsiteX4" fmla="*/ 242888 w 242888"/>
              <a:gd name="connsiteY4" fmla="*/ 190500 h 192881"/>
              <a:gd name="connsiteX5" fmla="*/ 42863 w 242888"/>
              <a:gd name="connsiteY5" fmla="*/ 192881 h 19288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42888" h="192881">
                <a:moveTo>
                  <a:pt x="42863" y="192881"/>
                </a:moveTo>
                <a:lnTo>
                  <a:pt x="0" y="52388"/>
                </a:lnTo>
                <a:lnTo>
                  <a:pt x="59532" y="2381"/>
                </a:lnTo>
                <a:lnTo>
                  <a:pt x="242888" y="0"/>
                </a:lnTo>
                <a:lnTo>
                  <a:pt x="242888" y="190500"/>
                </a:lnTo>
                <a:lnTo>
                  <a:pt x="42863" y="19288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587" name="テキスト ボックス 586"/>
          <p:cNvSpPr txBox="1"/>
          <p:nvPr/>
        </p:nvSpPr>
        <p:spPr>
          <a:xfrm>
            <a:off x="4662430" y="3152800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5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01" name="テキスト ボックス 600"/>
          <p:cNvSpPr txBox="1"/>
          <p:nvPr/>
        </p:nvSpPr>
        <p:spPr>
          <a:xfrm>
            <a:off x="5166486" y="1838756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+mn-ea"/>
              </a:rPr>
              <a:t>7</a:t>
            </a:r>
            <a:r>
              <a:rPr lang="en-US" altLang="ja-JP" sz="800" dirty="0" smtClean="0">
                <a:latin typeface="+mn-ea"/>
              </a:rPr>
              <a:t>2.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03" name="テキスト ボックス 602"/>
          <p:cNvSpPr txBox="1"/>
          <p:nvPr/>
        </p:nvSpPr>
        <p:spPr>
          <a:xfrm>
            <a:off x="5543214" y="2288704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 smtClean="0">
                <a:latin typeface="+mn-ea"/>
              </a:rPr>
              <a:t>27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04" name="テキスト ボックス 603"/>
          <p:cNvSpPr txBox="1"/>
          <p:nvPr/>
        </p:nvSpPr>
        <p:spPr>
          <a:xfrm>
            <a:off x="5183173" y="2819524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9.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05" name="テキスト ボックス 604"/>
          <p:cNvSpPr txBox="1"/>
          <p:nvPr/>
        </p:nvSpPr>
        <p:spPr>
          <a:xfrm>
            <a:off x="5543213" y="3152800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9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08" name="フリーフォーム 107"/>
          <p:cNvSpPr/>
          <p:nvPr/>
        </p:nvSpPr>
        <p:spPr>
          <a:xfrm>
            <a:off x="1782110" y="4546930"/>
            <a:ext cx="299556" cy="777769"/>
          </a:xfrm>
          <a:custGeom>
            <a:avLst/>
            <a:gdLst>
              <a:gd name="connsiteX0" fmla="*/ 0 w 154882"/>
              <a:gd name="connsiteY0" fmla="*/ 396141 h 399119"/>
              <a:gd name="connsiteX1" fmla="*/ 0 w 154882"/>
              <a:gd name="connsiteY1" fmla="*/ 0 h 399119"/>
              <a:gd name="connsiteX2" fmla="*/ 154882 w 154882"/>
              <a:gd name="connsiteY2" fmla="*/ 0 h 399119"/>
              <a:gd name="connsiteX3" fmla="*/ 154882 w 154882"/>
              <a:gd name="connsiteY3" fmla="*/ 399119 h 399119"/>
              <a:gd name="connsiteX4" fmla="*/ 0 w 154882"/>
              <a:gd name="connsiteY4" fmla="*/ 396141 h 3991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54882" h="399119">
                <a:moveTo>
                  <a:pt x="0" y="396141"/>
                </a:moveTo>
                <a:lnTo>
                  <a:pt x="0" y="0"/>
                </a:lnTo>
                <a:lnTo>
                  <a:pt x="154882" y="0"/>
                </a:lnTo>
                <a:lnTo>
                  <a:pt x="154882" y="399119"/>
                </a:lnTo>
                <a:lnTo>
                  <a:pt x="0" y="39614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109" name="フリーフォーム 108"/>
          <p:cNvSpPr/>
          <p:nvPr/>
        </p:nvSpPr>
        <p:spPr>
          <a:xfrm>
            <a:off x="1299477" y="4546618"/>
            <a:ext cx="482634" cy="557519"/>
          </a:xfrm>
          <a:custGeom>
            <a:avLst/>
            <a:gdLst>
              <a:gd name="connsiteX0" fmla="*/ 0 w 244237"/>
              <a:gd name="connsiteY0" fmla="*/ 282958 h 282958"/>
              <a:gd name="connsiteX1" fmla="*/ 2978 w 244237"/>
              <a:gd name="connsiteY1" fmla="*/ 0 h 282958"/>
              <a:gd name="connsiteX2" fmla="*/ 244237 w 244237"/>
              <a:gd name="connsiteY2" fmla="*/ 0 h 282958"/>
              <a:gd name="connsiteX3" fmla="*/ 244237 w 244237"/>
              <a:gd name="connsiteY3" fmla="*/ 282958 h 282958"/>
              <a:gd name="connsiteX4" fmla="*/ 0 w 244237"/>
              <a:gd name="connsiteY4" fmla="*/ 282958 h 2829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282958">
                <a:moveTo>
                  <a:pt x="0" y="282958"/>
                </a:moveTo>
                <a:cubicBezTo>
                  <a:pt x="993" y="188639"/>
                  <a:pt x="1985" y="94319"/>
                  <a:pt x="2978" y="0"/>
                </a:cubicBezTo>
                <a:lnTo>
                  <a:pt x="244237" y="0"/>
                </a:lnTo>
                <a:lnTo>
                  <a:pt x="244237" y="282958"/>
                </a:lnTo>
                <a:lnTo>
                  <a:pt x="0" y="282958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116" name="フリーフォーム 115"/>
          <p:cNvSpPr/>
          <p:nvPr/>
        </p:nvSpPr>
        <p:spPr>
          <a:xfrm>
            <a:off x="1299477" y="5104137"/>
            <a:ext cx="482634" cy="220561"/>
          </a:xfrm>
          <a:custGeom>
            <a:avLst/>
            <a:gdLst>
              <a:gd name="connsiteX0" fmla="*/ 0 w 244237"/>
              <a:gd name="connsiteY0" fmla="*/ 113183 h 113183"/>
              <a:gd name="connsiteX1" fmla="*/ 2979 w 244237"/>
              <a:gd name="connsiteY1" fmla="*/ 0 h 113183"/>
              <a:gd name="connsiteX2" fmla="*/ 244237 w 244237"/>
              <a:gd name="connsiteY2" fmla="*/ 0 h 113183"/>
              <a:gd name="connsiteX3" fmla="*/ 244237 w 244237"/>
              <a:gd name="connsiteY3" fmla="*/ 113183 h 113183"/>
              <a:gd name="connsiteX4" fmla="*/ 0 w 244237"/>
              <a:gd name="connsiteY4" fmla="*/ 113183 h 1131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113183">
                <a:moveTo>
                  <a:pt x="0" y="113183"/>
                </a:moveTo>
                <a:lnTo>
                  <a:pt x="2979" y="0"/>
                </a:lnTo>
                <a:lnTo>
                  <a:pt x="244237" y="0"/>
                </a:lnTo>
                <a:lnTo>
                  <a:pt x="244237" y="113183"/>
                </a:lnTo>
                <a:lnTo>
                  <a:pt x="0" y="11318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609" name="テキスト ボックス 608"/>
          <p:cNvSpPr txBox="1"/>
          <p:nvPr/>
        </p:nvSpPr>
        <p:spPr>
          <a:xfrm>
            <a:off x="1222733" y="4520952"/>
            <a:ext cx="631385" cy="2606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5.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11" name="テキスト ボックス 610"/>
          <p:cNvSpPr txBox="1"/>
          <p:nvPr/>
        </p:nvSpPr>
        <p:spPr>
          <a:xfrm>
            <a:off x="1222733" y="5124361"/>
            <a:ext cx="631385" cy="2606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0.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12" name="テキスト ボックス 611"/>
          <p:cNvSpPr txBox="1"/>
          <p:nvPr/>
        </p:nvSpPr>
        <p:spPr>
          <a:xfrm>
            <a:off x="1798797" y="4520952"/>
            <a:ext cx="631385" cy="2606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4.1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17" name="フリーフォーム 116"/>
          <p:cNvSpPr/>
          <p:nvPr/>
        </p:nvSpPr>
        <p:spPr>
          <a:xfrm>
            <a:off x="1307509" y="5435958"/>
            <a:ext cx="774157" cy="481751"/>
          </a:xfrm>
          <a:custGeom>
            <a:avLst/>
            <a:gdLst>
              <a:gd name="connsiteX0" fmla="*/ 0 w 393162"/>
              <a:gd name="connsiteY0" fmla="*/ 244237 h 247215"/>
              <a:gd name="connsiteX1" fmla="*/ 0 w 393162"/>
              <a:gd name="connsiteY1" fmla="*/ 0 h 247215"/>
              <a:gd name="connsiteX2" fmla="*/ 393162 w 393162"/>
              <a:gd name="connsiteY2" fmla="*/ 2978 h 247215"/>
              <a:gd name="connsiteX3" fmla="*/ 393162 w 393162"/>
              <a:gd name="connsiteY3" fmla="*/ 247215 h 247215"/>
              <a:gd name="connsiteX4" fmla="*/ 0 w 393162"/>
              <a:gd name="connsiteY4" fmla="*/ 244237 h 24721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3162" h="247215">
                <a:moveTo>
                  <a:pt x="0" y="244237"/>
                </a:moveTo>
                <a:lnTo>
                  <a:pt x="0" y="0"/>
                </a:lnTo>
                <a:lnTo>
                  <a:pt x="393162" y="2978"/>
                </a:lnTo>
                <a:lnTo>
                  <a:pt x="393162" y="247215"/>
                </a:lnTo>
                <a:lnTo>
                  <a:pt x="0" y="24423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146" name="フリーフォーム 145"/>
          <p:cNvSpPr/>
          <p:nvPr/>
        </p:nvSpPr>
        <p:spPr>
          <a:xfrm>
            <a:off x="1299476" y="5917709"/>
            <a:ext cx="782191" cy="307626"/>
          </a:xfrm>
          <a:custGeom>
            <a:avLst/>
            <a:gdLst>
              <a:gd name="connsiteX0" fmla="*/ 0 w 399119"/>
              <a:gd name="connsiteY0" fmla="*/ 157861 h 157861"/>
              <a:gd name="connsiteX1" fmla="*/ 2979 w 399119"/>
              <a:gd name="connsiteY1" fmla="*/ 2979 h 157861"/>
              <a:gd name="connsiteX2" fmla="*/ 399119 w 399119"/>
              <a:gd name="connsiteY2" fmla="*/ 0 h 157861"/>
              <a:gd name="connsiteX3" fmla="*/ 399119 w 399119"/>
              <a:gd name="connsiteY3" fmla="*/ 148926 h 157861"/>
              <a:gd name="connsiteX4" fmla="*/ 0 w 399119"/>
              <a:gd name="connsiteY4" fmla="*/ 157861 h 1578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9119" h="157861">
                <a:moveTo>
                  <a:pt x="0" y="157861"/>
                </a:moveTo>
                <a:lnTo>
                  <a:pt x="2979" y="2979"/>
                </a:lnTo>
                <a:lnTo>
                  <a:pt x="399119" y="0"/>
                </a:lnTo>
                <a:lnTo>
                  <a:pt x="399119" y="148926"/>
                </a:lnTo>
                <a:lnTo>
                  <a:pt x="0" y="15786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617" name="テキスト ボックス 616"/>
          <p:cNvSpPr txBox="1"/>
          <p:nvPr/>
        </p:nvSpPr>
        <p:spPr>
          <a:xfrm>
            <a:off x="1205566" y="5327991"/>
            <a:ext cx="631385" cy="2606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0.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18" name="テキスト ボックス 617"/>
          <p:cNvSpPr txBox="1"/>
          <p:nvPr/>
        </p:nvSpPr>
        <p:spPr>
          <a:xfrm>
            <a:off x="1205566" y="5942122"/>
            <a:ext cx="631385" cy="2606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9.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36" name="フリーフォーム 635"/>
          <p:cNvSpPr/>
          <p:nvPr/>
        </p:nvSpPr>
        <p:spPr>
          <a:xfrm>
            <a:off x="2711770" y="4552266"/>
            <a:ext cx="301822" cy="777771"/>
          </a:xfrm>
          <a:custGeom>
            <a:avLst/>
            <a:gdLst>
              <a:gd name="connsiteX0" fmla="*/ 0 w 154882"/>
              <a:gd name="connsiteY0" fmla="*/ 396141 h 399119"/>
              <a:gd name="connsiteX1" fmla="*/ 0 w 154882"/>
              <a:gd name="connsiteY1" fmla="*/ 0 h 399119"/>
              <a:gd name="connsiteX2" fmla="*/ 154882 w 154882"/>
              <a:gd name="connsiteY2" fmla="*/ 0 h 399119"/>
              <a:gd name="connsiteX3" fmla="*/ 154882 w 154882"/>
              <a:gd name="connsiteY3" fmla="*/ 399119 h 399119"/>
              <a:gd name="connsiteX4" fmla="*/ 0 w 154882"/>
              <a:gd name="connsiteY4" fmla="*/ 396141 h 3991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54882" h="399119">
                <a:moveTo>
                  <a:pt x="0" y="396141"/>
                </a:moveTo>
                <a:lnTo>
                  <a:pt x="0" y="0"/>
                </a:lnTo>
                <a:lnTo>
                  <a:pt x="154882" y="0"/>
                </a:lnTo>
                <a:lnTo>
                  <a:pt x="154882" y="399119"/>
                </a:lnTo>
                <a:lnTo>
                  <a:pt x="0" y="39614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637" name="フリーフォーム 636"/>
          <p:cNvSpPr/>
          <p:nvPr/>
        </p:nvSpPr>
        <p:spPr>
          <a:xfrm>
            <a:off x="2235819" y="4558069"/>
            <a:ext cx="475950" cy="551406"/>
          </a:xfrm>
          <a:custGeom>
            <a:avLst/>
            <a:gdLst>
              <a:gd name="connsiteX0" fmla="*/ 0 w 244237"/>
              <a:gd name="connsiteY0" fmla="*/ 282958 h 282958"/>
              <a:gd name="connsiteX1" fmla="*/ 2978 w 244237"/>
              <a:gd name="connsiteY1" fmla="*/ 0 h 282958"/>
              <a:gd name="connsiteX2" fmla="*/ 244237 w 244237"/>
              <a:gd name="connsiteY2" fmla="*/ 0 h 282958"/>
              <a:gd name="connsiteX3" fmla="*/ 244237 w 244237"/>
              <a:gd name="connsiteY3" fmla="*/ 282958 h 282958"/>
              <a:gd name="connsiteX4" fmla="*/ 0 w 244237"/>
              <a:gd name="connsiteY4" fmla="*/ 282958 h 2829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282958">
                <a:moveTo>
                  <a:pt x="0" y="282958"/>
                </a:moveTo>
                <a:cubicBezTo>
                  <a:pt x="993" y="188639"/>
                  <a:pt x="1985" y="94319"/>
                  <a:pt x="2978" y="0"/>
                </a:cubicBezTo>
                <a:lnTo>
                  <a:pt x="244237" y="0"/>
                </a:lnTo>
                <a:lnTo>
                  <a:pt x="244237" y="282958"/>
                </a:lnTo>
                <a:lnTo>
                  <a:pt x="0" y="282958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638" name="フリーフォーム 637"/>
          <p:cNvSpPr/>
          <p:nvPr/>
        </p:nvSpPr>
        <p:spPr>
          <a:xfrm>
            <a:off x="2236028" y="5109475"/>
            <a:ext cx="482186" cy="220562"/>
          </a:xfrm>
          <a:custGeom>
            <a:avLst/>
            <a:gdLst>
              <a:gd name="connsiteX0" fmla="*/ 0 w 244237"/>
              <a:gd name="connsiteY0" fmla="*/ 113183 h 113183"/>
              <a:gd name="connsiteX1" fmla="*/ 2979 w 244237"/>
              <a:gd name="connsiteY1" fmla="*/ 0 h 113183"/>
              <a:gd name="connsiteX2" fmla="*/ 244237 w 244237"/>
              <a:gd name="connsiteY2" fmla="*/ 0 h 113183"/>
              <a:gd name="connsiteX3" fmla="*/ 244237 w 244237"/>
              <a:gd name="connsiteY3" fmla="*/ 113183 h 113183"/>
              <a:gd name="connsiteX4" fmla="*/ 0 w 244237"/>
              <a:gd name="connsiteY4" fmla="*/ 113183 h 1131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113183">
                <a:moveTo>
                  <a:pt x="0" y="113183"/>
                </a:moveTo>
                <a:lnTo>
                  <a:pt x="2979" y="0"/>
                </a:lnTo>
                <a:lnTo>
                  <a:pt x="244237" y="0"/>
                </a:lnTo>
                <a:lnTo>
                  <a:pt x="244237" y="113183"/>
                </a:lnTo>
                <a:lnTo>
                  <a:pt x="0" y="11318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622" name="テキスト ボックス 621"/>
          <p:cNvSpPr txBox="1"/>
          <p:nvPr/>
        </p:nvSpPr>
        <p:spPr>
          <a:xfrm>
            <a:off x="2158836" y="4520952"/>
            <a:ext cx="631386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2.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23" name="テキスト ボックス 622"/>
          <p:cNvSpPr txBox="1"/>
          <p:nvPr/>
        </p:nvSpPr>
        <p:spPr>
          <a:xfrm>
            <a:off x="2158836" y="5124360"/>
            <a:ext cx="631386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0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24" name="テキスト ボックス 623"/>
          <p:cNvSpPr txBox="1"/>
          <p:nvPr/>
        </p:nvSpPr>
        <p:spPr>
          <a:xfrm>
            <a:off x="2734900" y="4520952"/>
            <a:ext cx="631386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56.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39" name="フリーフォーム 638"/>
          <p:cNvSpPr/>
          <p:nvPr/>
        </p:nvSpPr>
        <p:spPr>
          <a:xfrm>
            <a:off x="2236029" y="5440672"/>
            <a:ext cx="777564" cy="481753"/>
          </a:xfrm>
          <a:custGeom>
            <a:avLst/>
            <a:gdLst>
              <a:gd name="connsiteX0" fmla="*/ 0 w 393162"/>
              <a:gd name="connsiteY0" fmla="*/ 244237 h 247215"/>
              <a:gd name="connsiteX1" fmla="*/ 0 w 393162"/>
              <a:gd name="connsiteY1" fmla="*/ 0 h 247215"/>
              <a:gd name="connsiteX2" fmla="*/ 393162 w 393162"/>
              <a:gd name="connsiteY2" fmla="*/ 2978 h 247215"/>
              <a:gd name="connsiteX3" fmla="*/ 393162 w 393162"/>
              <a:gd name="connsiteY3" fmla="*/ 247215 h 247215"/>
              <a:gd name="connsiteX4" fmla="*/ 0 w 393162"/>
              <a:gd name="connsiteY4" fmla="*/ 244237 h 24721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3162" h="247215">
                <a:moveTo>
                  <a:pt x="0" y="244237"/>
                </a:moveTo>
                <a:lnTo>
                  <a:pt x="0" y="0"/>
                </a:lnTo>
                <a:lnTo>
                  <a:pt x="393162" y="2978"/>
                </a:lnTo>
                <a:lnTo>
                  <a:pt x="393162" y="247215"/>
                </a:lnTo>
                <a:lnTo>
                  <a:pt x="0" y="24423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640" name="フリーフォーム 639"/>
          <p:cNvSpPr/>
          <p:nvPr/>
        </p:nvSpPr>
        <p:spPr>
          <a:xfrm>
            <a:off x="2236028" y="5922425"/>
            <a:ext cx="777563" cy="305039"/>
          </a:xfrm>
          <a:custGeom>
            <a:avLst/>
            <a:gdLst>
              <a:gd name="connsiteX0" fmla="*/ 0 w 399119"/>
              <a:gd name="connsiteY0" fmla="*/ 157861 h 157861"/>
              <a:gd name="connsiteX1" fmla="*/ 2979 w 399119"/>
              <a:gd name="connsiteY1" fmla="*/ 2979 h 157861"/>
              <a:gd name="connsiteX2" fmla="*/ 399119 w 399119"/>
              <a:gd name="connsiteY2" fmla="*/ 0 h 157861"/>
              <a:gd name="connsiteX3" fmla="*/ 399119 w 399119"/>
              <a:gd name="connsiteY3" fmla="*/ 148926 h 157861"/>
              <a:gd name="connsiteX4" fmla="*/ 0 w 399119"/>
              <a:gd name="connsiteY4" fmla="*/ 157861 h 1578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9119" h="157861">
                <a:moveTo>
                  <a:pt x="0" y="157861"/>
                </a:moveTo>
                <a:lnTo>
                  <a:pt x="2979" y="2979"/>
                </a:lnTo>
                <a:lnTo>
                  <a:pt x="399119" y="0"/>
                </a:lnTo>
                <a:lnTo>
                  <a:pt x="399119" y="148926"/>
                </a:lnTo>
                <a:lnTo>
                  <a:pt x="0" y="15786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625" name="テキスト ボックス 624"/>
          <p:cNvSpPr txBox="1"/>
          <p:nvPr/>
        </p:nvSpPr>
        <p:spPr>
          <a:xfrm>
            <a:off x="2158836" y="5385048"/>
            <a:ext cx="631386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25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26" name="テキスト ボックス 625"/>
          <p:cNvSpPr txBox="1"/>
          <p:nvPr/>
        </p:nvSpPr>
        <p:spPr>
          <a:xfrm>
            <a:off x="2158836" y="6033120"/>
            <a:ext cx="631386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5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47" name="フリーフォーム 646"/>
          <p:cNvSpPr/>
          <p:nvPr/>
        </p:nvSpPr>
        <p:spPr>
          <a:xfrm>
            <a:off x="3627948" y="4555400"/>
            <a:ext cx="301821" cy="777771"/>
          </a:xfrm>
          <a:custGeom>
            <a:avLst/>
            <a:gdLst>
              <a:gd name="connsiteX0" fmla="*/ 0 w 154882"/>
              <a:gd name="connsiteY0" fmla="*/ 396141 h 399119"/>
              <a:gd name="connsiteX1" fmla="*/ 0 w 154882"/>
              <a:gd name="connsiteY1" fmla="*/ 0 h 399119"/>
              <a:gd name="connsiteX2" fmla="*/ 154882 w 154882"/>
              <a:gd name="connsiteY2" fmla="*/ 0 h 399119"/>
              <a:gd name="connsiteX3" fmla="*/ 154882 w 154882"/>
              <a:gd name="connsiteY3" fmla="*/ 399119 h 399119"/>
              <a:gd name="connsiteX4" fmla="*/ 0 w 154882"/>
              <a:gd name="connsiteY4" fmla="*/ 396141 h 3991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54882" h="399119">
                <a:moveTo>
                  <a:pt x="0" y="396141"/>
                </a:moveTo>
                <a:lnTo>
                  <a:pt x="0" y="0"/>
                </a:lnTo>
                <a:lnTo>
                  <a:pt x="154882" y="0"/>
                </a:lnTo>
                <a:lnTo>
                  <a:pt x="154882" y="399119"/>
                </a:lnTo>
                <a:lnTo>
                  <a:pt x="0" y="39614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648" name="フリーフォーム 647"/>
          <p:cNvSpPr/>
          <p:nvPr/>
        </p:nvSpPr>
        <p:spPr>
          <a:xfrm>
            <a:off x="3151402" y="4553494"/>
            <a:ext cx="471587" cy="555981"/>
          </a:xfrm>
          <a:custGeom>
            <a:avLst/>
            <a:gdLst>
              <a:gd name="connsiteX0" fmla="*/ 0 w 244237"/>
              <a:gd name="connsiteY0" fmla="*/ 282958 h 282958"/>
              <a:gd name="connsiteX1" fmla="*/ 2978 w 244237"/>
              <a:gd name="connsiteY1" fmla="*/ 0 h 282958"/>
              <a:gd name="connsiteX2" fmla="*/ 244237 w 244237"/>
              <a:gd name="connsiteY2" fmla="*/ 0 h 282958"/>
              <a:gd name="connsiteX3" fmla="*/ 244237 w 244237"/>
              <a:gd name="connsiteY3" fmla="*/ 282958 h 282958"/>
              <a:gd name="connsiteX4" fmla="*/ 0 w 244237"/>
              <a:gd name="connsiteY4" fmla="*/ 282958 h 2829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282958">
                <a:moveTo>
                  <a:pt x="0" y="282958"/>
                </a:moveTo>
                <a:cubicBezTo>
                  <a:pt x="993" y="188639"/>
                  <a:pt x="1985" y="94319"/>
                  <a:pt x="2978" y="0"/>
                </a:cubicBezTo>
                <a:lnTo>
                  <a:pt x="244237" y="0"/>
                </a:lnTo>
                <a:lnTo>
                  <a:pt x="244237" y="282958"/>
                </a:lnTo>
                <a:lnTo>
                  <a:pt x="0" y="282958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649" name="フリーフォーム 648"/>
          <p:cNvSpPr/>
          <p:nvPr/>
        </p:nvSpPr>
        <p:spPr>
          <a:xfrm>
            <a:off x="3149913" y="5112609"/>
            <a:ext cx="478035" cy="220562"/>
          </a:xfrm>
          <a:custGeom>
            <a:avLst/>
            <a:gdLst>
              <a:gd name="connsiteX0" fmla="*/ 0 w 244237"/>
              <a:gd name="connsiteY0" fmla="*/ 113183 h 113183"/>
              <a:gd name="connsiteX1" fmla="*/ 2979 w 244237"/>
              <a:gd name="connsiteY1" fmla="*/ 0 h 113183"/>
              <a:gd name="connsiteX2" fmla="*/ 244237 w 244237"/>
              <a:gd name="connsiteY2" fmla="*/ 0 h 113183"/>
              <a:gd name="connsiteX3" fmla="*/ 244237 w 244237"/>
              <a:gd name="connsiteY3" fmla="*/ 113183 h 113183"/>
              <a:gd name="connsiteX4" fmla="*/ 0 w 244237"/>
              <a:gd name="connsiteY4" fmla="*/ 113183 h 1131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113183">
                <a:moveTo>
                  <a:pt x="0" y="113183"/>
                </a:moveTo>
                <a:lnTo>
                  <a:pt x="2979" y="0"/>
                </a:lnTo>
                <a:lnTo>
                  <a:pt x="244237" y="0"/>
                </a:lnTo>
                <a:lnTo>
                  <a:pt x="244237" y="113183"/>
                </a:lnTo>
                <a:lnTo>
                  <a:pt x="0" y="11318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632" name="テキスト ボックス 631"/>
          <p:cNvSpPr txBox="1"/>
          <p:nvPr/>
        </p:nvSpPr>
        <p:spPr>
          <a:xfrm>
            <a:off x="3078254" y="4520952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.8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33" name="テキスト ボックス 632"/>
          <p:cNvSpPr txBox="1"/>
          <p:nvPr/>
        </p:nvSpPr>
        <p:spPr>
          <a:xfrm>
            <a:off x="3078254" y="5124360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.1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35" name="テキスト ボックス 634"/>
          <p:cNvSpPr txBox="1"/>
          <p:nvPr/>
        </p:nvSpPr>
        <p:spPr>
          <a:xfrm>
            <a:off x="3654318" y="4520952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4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50" name="フリーフォーム 649"/>
          <p:cNvSpPr/>
          <p:nvPr/>
        </p:nvSpPr>
        <p:spPr>
          <a:xfrm>
            <a:off x="3161871" y="5435958"/>
            <a:ext cx="766163" cy="492254"/>
          </a:xfrm>
          <a:custGeom>
            <a:avLst/>
            <a:gdLst>
              <a:gd name="connsiteX0" fmla="*/ 0 w 393162"/>
              <a:gd name="connsiteY0" fmla="*/ 244237 h 247215"/>
              <a:gd name="connsiteX1" fmla="*/ 0 w 393162"/>
              <a:gd name="connsiteY1" fmla="*/ 0 h 247215"/>
              <a:gd name="connsiteX2" fmla="*/ 393162 w 393162"/>
              <a:gd name="connsiteY2" fmla="*/ 2978 h 247215"/>
              <a:gd name="connsiteX3" fmla="*/ 393162 w 393162"/>
              <a:gd name="connsiteY3" fmla="*/ 247215 h 247215"/>
              <a:gd name="connsiteX4" fmla="*/ 0 w 393162"/>
              <a:gd name="connsiteY4" fmla="*/ 244237 h 24721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3162" h="247215">
                <a:moveTo>
                  <a:pt x="0" y="244237"/>
                </a:moveTo>
                <a:lnTo>
                  <a:pt x="0" y="0"/>
                </a:lnTo>
                <a:lnTo>
                  <a:pt x="393162" y="2978"/>
                </a:lnTo>
                <a:lnTo>
                  <a:pt x="393162" y="247215"/>
                </a:lnTo>
                <a:lnTo>
                  <a:pt x="0" y="24423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651" name="フリーフォーム 650"/>
          <p:cNvSpPr/>
          <p:nvPr/>
        </p:nvSpPr>
        <p:spPr>
          <a:xfrm>
            <a:off x="3151402" y="5928210"/>
            <a:ext cx="776631" cy="292551"/>
          </a:xfrm>
          <a:custGeom>
            <a:avLst/>
            <a:gdLst>
              <a:gd name="connsiteX0" fmla="*/ 0 w 399119"/>
              <a:gd name="connsiteY0" fmla="*/ 157861 h 157861"/>
              <a:gd name="connsiteX1" fmla="*/ 2979 w 399119"/>
              <a:gd name="connsiteY1" fmla="*/ 2979 h 157861"/>
              <a:gd name="connsiteX2" fmla="*/ 399119 w 399119"/>
              <a:gd name="connsiteY2" fmla="*/ 0 h 157861"/>
              <a:gd name="connsiteX3" fmla="*/ 399119 w 399119"/>
              <a:gd name="connsiteY3" fmla="*/ 148926 h 157861"/>
              <a:gd name="connsiteX4" fmla="*/ 0 w 399119"/>
              <a:gd name="connsiteY4" fmla="*/ 157861 h 1578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9119" h="157861">
                <a:moveTo>
                  <a:pt x="0" y="157861"/>
                </a:moveTo>
                <a:lnTo>
                  <a:pt x="2979" y="2979"/>
                </a:lnTo>
                <a:lnTo>
                  <a:pt x="399119" y="0"/>
                </a:lnTo>
                <a:lnTo>
                  <a:pt x="399119" y="148926"/>
                </a:lnTo>
                <a:lnTo>
                  <a:pt x="0" y="15786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646" name="テキスト ボックス 645"/>
          <p:cNvSpPr txBox="1"/>
          <p:nvPr/>
        </p:nvSpPr>
        <p:spPr>
          <a:xfrm>
            <a:off x="3098786" y="5412392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1.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656" name="テキスト ボックス 655"/>
          <p:cNvSpPr txBox="1"/>
          <p:nvPr/>
        </p:nvSpPr>
        <p:spPr>
          <a:xfrm>
            <a:off x="3098786" y="6033120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8.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727" name="フリーフォーム 726"/>
          <p:cNvSpPr/>
          <p:nvPr/>
        </p:nvSpPr>
        <p:spPr>
          <a:xfrm>
            <a:off x="4630722" y="4546618"/>
            <a:ext cx="301821" cy="771966"/>
          </a:xfrm>
          <a:custGeom>
            <a:avLst/>
            <a:gdLst>
              <a:gd name="connsiteX0" fmla="*/ 0 w 154882"/>
              <a:gd name="connsiteY0" fmla="*/ 396141 h 399119"/>
              <a:gd name="connsiteX1" fmla="*/ 0 w 154882"/>
              <a:gd name="connsiteY1" fmla="*/ 0 h 399119"/>
              <a:gd name="connsiteX2" fmla="*/ 154882 w 154882"/>
              <a:gd name="connsiteY2" fmla="*/ 0 h 399119"/>
              <a:gd name="connsiteX3" fmla="*/ 154882 w 154882"/>
              <a:gd name="connsiteY3" fmla="*/ 399119 h 399119"/>
              <a:gd name="connsiteX4" fmla="*/ 0 w 154882"/>
              <a:gd name="connsiteY4" fmla="*/ 396141 h 3991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54882" h="399119">
                <a:moveTo>
                  <a:pt x="0" y="396141"/>
                </a:moveTo>
                <a:lnTo>
                  <a:pt x="0" y="0"/>
                </a:lnTo>
                <a:lnTo>
                  <a:pt x="154882" y="0"/>
                </a:lnTo>
                <a:lnTo>
                  <a:pt x="154882" y="399119"/>
                </a:lnTo>
                <a:lnTo>
                  <a:pt x="0" y="39614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728" name="フリーフォーム 727"/>
          <p:cNvSpPr/>
          <p:nvPr/>
        </p:nvSpPr>
        <p:spPr>
          <a:xfrm>
            <a:off x="4154773" y="4546618"/>
            <a:ext cx="475949" cy="551405"/>
          </a:xfrm>
          <a:custGeom>
            <a:avLst/>
            <a:gdLst>
              <a:gd name="connsiteX0" fmla="*/ 0 w 244237"/>
              <a:gd name="connsiteY0" fmla="*/ 282958 h 282958"/>
              <a:gd name="connsiteX1" fmla="*/ 2978 w 244237"/>
              <a:gd name="connsiteY1" fmla="*/ 0 h 282958"/>
              <a:gd name="connsiteX2" fmla="*/ 244237 w 244237"/>
              <a:gd name="connsiteY2" fmla="*/ 0 h 282958"/>
              <a:gd name="connsiteX3" fmla="*/ 244237 w 244237"/>
              <a:gd name="connsiteY3" fmla="*/ 282958 h 282958"/>
              <a:gd name="connsiteX4" fmla="*/ 0 w 244237"/>
              <a:gd name="connsiteY4" fmla="*/ 282958 h 2829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282958">
                <a:moveTo>
                  <a:pt x="0" y="282958"/>
                </a:moveTo>
                <a:cubicBezTo>
                  <a:pt x="993" y="188639"/>
                  <a:pt x="1985" y="94319"/>
                  <a:pt x="2978" y="0"/>
                </a:cubicBezTo>
                <a:lnTo>
                  <a:pt x="244237" y="0"/>
                </a:lnTo>
                <a:lnTo>
                  <a:pt x="244237" y="282958"/>
                </a:lnTo>
                <a:lnTo>
                  <a:pt x="0" y="282958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729" name="フリーフォーム 728"/>
          <p:cNvSpPr/>
          <p:nvPr/>
        </p:nvSpPr>
        <p:spPr>
          <a:xfrm>
            <a:off x="4154772" y="5098023"/>
            <a:ext cx="475949" cy="220561"/>
          </a:xfrm>
          <a:custGeom>
            <a:avLst/>
            <a:gdLst>
              <a:gd name="connsiteX0" fmla="*/ 0 w 244237"/>
              <a:gd name="connsiteY0" fmla="*/ 113183 h 113183"/>
              <a:gd name="connsiteX1" fmla="*/ 2979 w 244237"/>
              <a:gd name="connsiteY1" fmla="*/ 0 h 113183"/>
              <a:gd name="connsiteX2" fmla="*/ 244237 w 244237"/>
              <a:gd name="connsiteY2" fmla="*/ 0 h 113183"/>
              <a:gd name="connsiteX3" fmla="*/ 244237 w 244237"/>
              <a:gd name="connsiteY3" fmla="*/ 113183 h 113183"/>
              <a:gd name="connsiteX4" fmla="*/ 0 w 244237"/>
              <a:gd name="connsiteY4" fmla="*/ 113183 h 1131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113183">
                <a:moveTo>
                  <a:pt x="0" y="113183"/>
                </a:moveTo>
                <a:lnTo>
                  <a:pt x="2979" y="0"/>
                </a:lnTo>
                <a:lnTo>
                  <a:pt x="244237" y="0"/>
                </a:lnTo>
                <a:lnTo>
                  <a:pt x="244237" y="113183"/>
                </a:lnTo>
                <a:lnTo>
                  <a:pt x="0" y="11318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759" name="テキスト ボックス 758"/>
          <p:cNvSpPr txBox="1"/>
          <p:nvPr/>
        </p:nvSpPr>
        <p:spPr>
          <a:xfrm>
            <a:off x="4103054" y="4520952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1.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760" name="テキスト ボックス 759"/>
          <p:cNvSpPr txBox="1"/>
          <p:nvPr/>
        </p:nvSpPr>
        <p:spPr>
          <a:xfrm>
            <a:off x="4103054" y="5124360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.5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761" name="テキスト ボックス 760"/>
          <p:cNvSpPr txBox="1"/>
          <p:nvPr/>
        </p:nvSpPr>
        <p:spPr>
          <a:xfrm>
            <a:off x="4662430" y="4520952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0.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730" name="フリーフォーム 729"/>
          <p:cNvSpPr/>
          <p:nvPr/>
        </p:nvSpPr>
        <p:spPr>
          <a:xfrm>
            <a:off x="4169084" y="5438086"/>
            <a:ext cx="764690" cy="481752"/>
          </a:xfrm>
          <a:custGeom>
            <a:avLst/>
            <a:gdLst>
              <a:gd name="connsiteX0" fmla="*/ 0 w 393162"/>
              <a:gd name="connsiteY0" fmla="*/ 244237 h 247215"/>
              <a:gd name="connsiteX1" fmla="*/ 0 w 393162"/>
              <a:gd name="connsiteY1" fmla="*/ 0 h 247215"/>
              <a:gd name="connsiteX2" fmla="*/ 393162 w 393162"/>
              <a:gd name="connsiteY2" fmla="*/ 2978 h 247215"/>
              <a:gd name="connsiteX3" fmla="*/ 393162 w 393162"/>
              <a:gd name="connsiteY3" fmla="*/ 247215 h 247215"/>
              <a:gd name="connsiteX4" fmla="*/ 0 w 393162"/>
              <a:gd name="connsiteY4" fmla="*/ 244237 h 24721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3162" h="247215">
                <a:moveTo>
                  <a:pt x="0" y="244237"/>
                </a:moveTo>
                <a:lnTo>
                  <a:pt x="0" y="0"/>
                </a:lnTo>
                <a:lnTo>
                  <a:pt x="393162" y="2978"/>
                </a:lnTo>
                <a:lnTo>
                  <a:pt x="393162" y="247215"/>
                </a:lnTo>
                <a:lnTo>
                  <a:pt x="0" y="24423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731" name="フリーフォーム 730"/>
          <p:cNvSpPr/>
          <p:nvPr/>
        </p:nvSpPr>
        <p:spPr>
          <a:xfrm>
            <a:off x="4162792" y="5919838"/>
            <a:ext cx="770982" cy="307626"/>
          </a:xfrm>
          <a:custGeom>
            <a:avLst/>
            <a:gdLst>
              <a:gd name="connsiteX0" fmla="*/ 0 w 399119"/>
              <a:gd name="connsiteY0" fmla="*/ 157861 h 157861"/>
              <a:gd name="connsiteX1" fmla="*/ 2979 w 399119"/>
              <a:gd name="connsiteY1" fmla="*/ 2979 h 157861"/>
              <a:gd name="connsiteX2" fmla="*/ 399119 w 399119"/>
              <a:gd name="connsiteY2" fmla="*/ 0 h 157861"/>
              <a:gd name="connsiteX3" fmla="*/ 399119 w 399119"/>
              <a:gd name="connsiteY3" fmla="*/ 148926 h 157861"/>
              <a:gd name="connsiteX4" fmla="*/ 0 w 399119"/>
              <a:gd name="connsiteY4" fmla="*/ 157861 h 1578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9119" h="157861">
                <a:moveTo>
                  <a:pt x="0" y="157861"/>
                </a:moveTo>
                <a:lnTo>
                  <a:pt x="2979" y="2979"/>
                </a:lnTo>
                <a:lnTo>
                  <a:pt x="399119" y="0"/>
                </a:lnTo>
                <a:lnTo>
                  <a:pt x="399119" y="148926"/>
                </a:lnTo>
                <a:lnTo>
                  <a:pt x="0" y="15786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762" name="テキスト ボックス 761"/>
          <p:cNvSpPr txBox="1"/>
          <p:nvPr/>
        </p:nvSpPr>
        <p:spPr>
          <a:xfrm>
            <a:off x="4103053" y="5412392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7.9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763" name="テキスト ボックス 762"/>
          <p:cNvSpPr txBox="1"/>
          <p:nvPr/>
        </p:nvSpPr>
        <p:spPr>
          <a:xfrm>
            <a:off x="4086366" y="6033120"/>
            <a:ext cx="631385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2.1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738" name="フリーフォーム 737"/>
          <p:cNvSpPr/>
          <p:nvPr/>
        </p:nvSpPr>
        <p:spPr>
          <a:xfrm>
            <a:off x="5543214" y="4532638"/>
            <a:ext cx="302199" cy="769661"/>
          </a:xfrm>
          <a:custGeom>
            <a:avLst/>
            <a:gdLst>
              <a:gd name="connsiteX0" fmla="*/ 0 w 154882"/>
              <a:gd name="connsiteY0" fmla="*/ 396141 h 399119"/>
              <a:gd name="connsiteX1" fmla="*/ 0 w 154882"/>
              <a:gd name="connsiteY1" fmla="*/ 0 h 399119"/>
              <a:gd name="connsiteX2" fmla="*/ 154882 w 154882"/>
              <a:gd name="connsiteY2" fmla="*/ 0 h 399119"/>
              <a:gd name="connsiteX3" fmla="*/ 154882 w 154882"/>
              <a:gd name="connsiteY3" fmla="*/ 399119 h 399119"/>
              <a:gd name="connsiteX4" fmla="*/ 0 w 154882"/>
              <a:gd name="connsiteY4" fmla="*/ 396141 h 39911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54882" h="399119">
                <a:moveTo>
                  <a:pt x="0" y="396141"/>
                </a:moveTo>
                <a:lnTo>
                  <a:pt x="0" y="0"/>
                </a:lnTo>
                <a:lnTo>
                  <a:pt x="154882" y="0"/>
                </a:lnTo>
                <a:lnTo>
                  <a:pt x="154882" y="399119"/>
                </a:lnTo>
                <a:lnTo>
                  <a:pt x="0" y="39614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739" name="フリーフォーム 738"/>
          <p:cNvSpPr/>
          <p:nvPr/>
        </p:nvSpPr>
        <p:spPr>
          <a:xfrm>
            <a:off x="5049206" y="4530331"/>
            <a:ext cx="494008" cy="551405"/>
          </a:xfrm>
          <a:custGeom>
            <a:avLst/>
            <a:gdLst>
              <a:gd name="connsiteX0" fmla="*/ 0 w 244237"/>
              <a:gd name="connsiteY0" fmla="*/ 282958 h 282958"/>
              <a:gd name="connsiteX1" fmla="*/ 2978 w 244237"/>
              <a:gd name="connsiteY1" fmla="*/ 0 h 282958"/>
              <a:gd name="connsiteX2" fmla="*/ 244237 w 244237"/>
              <a:gd name="connsiteY2" fmla="*/ 0 h 282958"/>
              <a:gd name="connsiteX3" fmla="*/ 244237 w 244237"/>
              <a:gd name="connsiteY3" fmla="*/ 282958 h 282958"/>
              <a:gd name="connsiteX4" fmla="*/ 0 w 244237"/>
              <a:gd name="connsiteY4" fmla="*/ 282958 h 2829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282958">
                <a:moveTo>
                  <a:pt x="0" y="282958"/>
                </a:moveTo>
                <a:cubicBezTo>
                  <a:pt x="993" y="188639"/>
                  <a:pt x="1985" y="94319"/>
                  <a:pt x="2978" y="0"/>
                </a:cubicBezTo>
                <a:lnTo>
                  <a:pt x="244237" y="0"/>
                </a:lnTo>
                <a:lnTo>
                  <a:pt x="244237" y="282958"/>
                </a:lnTo>
                <a:lnTo>
                  <a:pt x="0" y="282958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740" name="フリーフォーム 739"/>
          <p:cNvSpPr/>
          <p:nvPr/>
        </p:nvSpPr>
        <p:spPr>
          <a:xfrm>
            <a:off x="5049206" y="5081737"/>
            <a:ext cx="494008" cy="220562"/>
          </a:xfrm>
          <a:custGeom>
            <a:avLst/>
            <a:gdLst>
              <a:gd name="connsiteX0" fmla="*/ 0 w 244237"/>
              <a:gd name="connsiteY0" fmla="*/ 113183 h 113183"/>
              <a:gd name="connsiteX1" fmla="*/ 2979 w 244237"/>
              <a:gd name="connsiteY1" fmla="*/ 0 h 113183"/>
              <a:gd name="connsiteX2" fmla="*/ 244237 w 244237"/>
              <a:gd name="connsiteY2" fmla="*/ 0 h 113183"/>
              <a:gd name="connsiteX3" fmla="*/ 244237 w 244237"/>
              <a:gd name="connsiteY3" fmla="*/ 113183 h 113183"/>
              <a:gd name="connsiteX4" fmla="*/ 0 w 244237"/>
              <a:gd name="connsiteY4" fmla="*/ 113183 h 1131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4237" h="113183">
                <a:moveTo>
                  <a:pt x="0" y="113183"/>
                </a:moveTo>
                <a:lnTo>
                  <a:pt x="2979" y="0"/>
                </a:lnTo>
                <a:lnTo>
                  <a:pt x="244237" y="0"/>
                </a:lnTo>
                <a:lnTo>
                  <a:pt x="244237" y="113183"/>
                </a:lnTo>
                <a:lnTo>
                  <a:pt x="0" y="11318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773" name="テキスト ボックス 772"/>
          <p:cNvSpPr txBox="1"/>
          <p:nvPr/>
        </p:nvSpPr>
        <p:spPr>
          <a:xfrm>
            <a:off x="5010693" y="4520952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.1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774" name="テキスト ボックス 773"/>
          <p:cNvSpPr txBox="1"/>
          <p:nvPr/>
        </p:nvSpPr>
        <p:spPr>
          <a:xfrm>
            <a:off x="4987829" y="5124360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+mn-ea"/>
              </a:rPr>
              <a:t>3</a:t>
            </a:r>
            <a:r>
              <a:rPr lang="en-US" altLang="ja-JP" sz="800" dirty="0" smtClean="0">
                <a:latin typeface="+mn-ea"/>
              </a:rPr>
              <a:t>.15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775" name="テキスト ボックス 774"/>
          <p:cNvSpPr txBox="1"/>
          <p:nvPr/>
        </p:nvSpPr>
        <p:spPr>
          <a:xfrm>
            <a:off x="5543214" y="4520952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7.6</a:t>
            </a:r>
          </a:p>
        </p:txBody>
      </p:sp>
      <p:sp>
        <p:nvSpPr>
          <p:cNvPr id="741" name="フリーフォーム 740"/>
          <p:cNvSpPr/>
          <p:nvPr/>
        </p:nvSpPr>
        <p:spPr>
          <a:xfrm>
            <a:off x="5067350" y="5450344"/>
            <a:ext cx="774984" cy="481753"/>
          </a:xfrm>
          <a:custGeom>
            <a:avLst/>
            <a:gdLst>
              <a:gd name="connsiteX0" fmla="*/ 0 w 393162"/>
              <a:gd name="connsiteY0" fmla="*/ 244237 h 247215"/>
              <a:gd name="connsiteX1" fmla="*/ 0 w 393162"/>
              <a:gd name="connsiteY1" fmla="*/ 0 h 247215"/>
              <a:gd name="connsiteX2" fmla="*/ 393162 w 393162"/>
              <a:gd name="connsiteY2" fmla="*/ 2978 h 247215"/>
              <a:gd name="connsiteX3" fmla="*/ 393162 w 393162"/>
              <a:gd name="connsiteY3" fmla="*/ 247215 h 247215"/>
              <a:gd name="connsiteX4" fmla="*/ 0 w 393162"/>
              <a:gd name="connsiteY4" fmla="*/ 244237 h 24721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3162" h="247215">
                <a:moveTo>
                  <a:pt x="0" y="244237"/>
                </a:moveTo>
                <a:lnTo>
                  <a:pt x="0" y="0"/>
                </a:lnTo>
                <a:lnTo>
                  <a:pt x="393162" y="2978"/>
                </a:lnTo>
                <a:lnTo>
                  <a:pt x="393162" y="247215"/>
                </a:lnTo>
                <a:lnTo>
                  <a:pt x="0" y="24423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742" name="フリーフォーム 741"/>
          <p:cNvSpPr/>
          <p:nvPr/>
        </p:nvSpPr>
        <p:spPr>
          <a:xfrm>
            <a:off x="5049206" y="5932098"/>
            <a:ext cx="793127" cy="293238"/>
          </a:xfrm>
          <a:custGeom>
            <a:avLst/>
            <a:gdLst>
              <a:gd name="connsiteX0" fmla="*/ 0 w 399119"/>
              <a:gd name="connsiteY0" fmla="*/ 157861 h 157861"/>
              <a:gd name="connsiteX1" fmla="*/ 2979 w 399119"/>
              <a:gd name="connsiteY1" fmla="*/ 2979 h 157861"/>
              <a:gd name="connsiteX2" fmla="*/ 399119 w 399119"/>
              <a:gd name="connsiteY2" fmla="*/ 0 h 157861"/>
              <a:gd name="connsiteX3" fmla="*/ 399119 w 399119"/>
              <a:gd name="connsiteY3" fmla="*/ 148926 h 157861"/>
              <a:gd name="connsiteX4" fmla="*/ 0 w 399119"/>
              <a:gd name="connsiteY4" fmla="*/ 157861 h 1578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9119" h="157861">
                <a:moveTo>
                  <a:pt x="0" y="157861"/>
                </a:moveTo>
                <a:lnTo>
                  <a:pt x="2979" y="2979"/>
                </a:lnTo>
                <a:lnTo>
                  <a:pt x="399119" y="0"/>
                </a:lnTo>
                <a:lnTo>
                  <a:pt x="399119" y="148926"/>
                </a:lnTo>
                <a:lnTo>
                  <a:pt x="0" y="15786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776" name="テキスト ボックス 775"/>
          <p:cNvSpPr txBox="1"/>
          <p:nvPr/>
        </p:nvSpPr>
        <p:spPr>
          <a:xfrm>
            <a:off x="4996907" y="5412392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1.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777" name="テキスト ボックス 776"/>
          <p:cNvSpPr txBox="1"/>
          <p:nvPr/>
        </p:nvSpPr>
        <p:spPr>
          <a:xfrm>
            <a:off x="4996907" y="6033120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8.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502" name="四角形吹き出し 501"/>
          <p:cNvSpPr/>
          <p:nvPr/>
        </p:nvSpPr>
        <p:spPr>
          <a:xfrm>
            <a:off x="4086366" y="403865"/>
            <a:ext cx="1904132" cy="5917287"/>
          </a:xfrm>
          <a:prstGeom prst="wedgeRectCallout">
            <a:avLst>
              <a:gd name="adj1" fmla="val 40111"/>
              <a:gd name="adj2" fmla="val 45623"/>
            </a:avLst>
          </a:prstGeom>
          <a:noFill/>
          <a:ln>
            <a:solidFill>
              <a:srgbClr val="000000"/>
            </a:solidFill>
            <a:prstDash val="dot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 dirty="0">
              <a:solidFill>
                <a:schemeClr val="tx1"/>
              </a:solidFill>
            </a:endParaRPr>
          </a:p>
        </p:txBody>
      </p:sp>
      <p:sp>
        <p:nvSpPr>
          <p:cNvPr id="294" name="フリーフォーム 293"/>
          <p:cNvSpPr/>
          <p:nvPr/>
        </p:nvSpPr>
        <p:spPr>
          <a:xfrm>
            <a:off x="5075108" y="956107"/>
            <a:ext cx="770305" cy="575408"/>
          </a:xfrm>
          <a:custGeom>
            <a:avLst/>
            <a:gdLst>
              <a:gd name="connsiteX0" fmla="*/ 0 w 397669"/>
              <a:gd name="connsiteY0" fmla="*/ 295275 h 295275"/>
              <a:gd name="connsiteX1" fmla="*/ 0 w 397669"/>
              <a:gd name="connsiteY1" fmla="*/ 0 h 295275"/>
              <a:gd name="connsiteX2" fmla="*/ 397669 w 397669"/>
              <a:gd name="connsiteY2" fmla="*/ 0 h 295275"/>
              <a:gd name="connsiteX3" fmla="*/ 397669 w 397669"/>
              <a:gd name="connsiteY3" fmla="*/ 76200 h 295275"/>
              <a:gd name="connsiteX4" fmla="*/ 0 w 397669"/>
              <a:gd name="connsiteY4" fmla="*/ 295275 h 295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7669" h="295275">
                <a:moveTo>
                  <a:pt x="0" y="295275"/>
                </a:moveTo>
                <a:lnTo>
                  <a:pt x="0" y="0"/>
                </a:lnTo>
                <a:lnTo>
                  <a:pt x="397669" y="0"/>
                </a:lnTo>
                <a:lnTo>
                  <a:pt x="397669" y="76200"/>
                </a:lnTo>
                <a:lnTo>
                  <a:pt x="0" y="295275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295" name="フリーフォーム 294"/>
          <p:cNvSpPr/>
          <p:nvPr/>
        </p:nvSpPr>
        <p:spPr>
          <a:xfrm>
            <a:off x="5075108" y="1109239"/>
            <a:ext cx="770305" cy="621811"/>
          </a:xfrm>
          <a:custGeom>
            <a:avLst/>
            <a:gdLst>
              <a:gd name="connsiteX0" fmla="*/ 0 w 390525"/>
              <a:gd name="connsiteY0" fmla="*/ 319087 h 319087"/>
              <a:gd name="connsiteX1" fmla="*/ 0 w 390525"/>
              <a:gd name="connsiteY1" fmla="*/ 216694 h 319087"/>
              <a:gd name="connsiteX2" fmla="*/ 390525 w 390525"/>
              <a:gd name="connsiteY2" fmla="*/ 0 h 319087"/>
              <a:gd name="connsiteX3" fmla="*/ 390525 w 390525"/>
              <a:gd name="connsiteY3" fmla="*/ 316706 h 319087"/>
              <a:gd name="connsiteX4" fmla="*/ 0 w 390525"/>
              <a:gd name="connsiteY4" fmla="*/ 319087 h 3190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0525" h="319087">
                <a:moveTo>
                  <a:pt x="0" y="319087"/>
                </a:moveTo>
                <a:lnTo>
                  <a:pt x="0" y="216694"/>
                </a:lnTo>
                <a:lnTo>
                  <a:pt x="390525" y="0"/>
                </a:lnTo>
                <a:lnTo>
                  <a:pt x="390525" y="316706"/>
                </a:lnTo>
                <a:lnTo>
                  <a:pt x="0" y="31908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591" name="テキスト ボックス 590"/>
          <p:cNvSpPr txBox="1"/>
          <p:nvPr/>
        </p:nvSpPr>
        <p:spPr>
          <a:xfrm>
            <a:off x="5543214" y="1538074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1.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590" name="テキスト ボックス 589"/>
          <p:cNvSpPr txBox="1"/>
          <p:nvPr/>
        </p:nvSpPr>
        <p:spPr>
          <a:xfrm>
            <a:off x="5022470" y="920552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8</a:t>
            </a:r>
            <a:r>
              <a:rPr kumimoji="1" lang="en-US" altLang="ja-JP" sz="800" dirty="0" smtClean="0">
                <a:latin typeface="+mn-ea"/>
              </a:rPr>
              <a:t>.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82" name="フリーフォーム 281"/>
          <p:cNvSpPr/>
          <p:nvPr/>
        </p:nvSpPr>
        <p:spPr>
          <a:xfrm>
            <a:off x="4161878" y="962955"/>
            <a:ext cx="769985" cy="575408"/>
          </a:xfrm>
          <a:custGeom>
            <a:avLst/>
            <a:gdLst>
              <a:gd name="connsiteX0" fmla="*/ 0 w 397669"/>
              <a:gd name="connsiteY0" fmla="*/ 295275 h 295275"/>
              <a:gd name="connsiteX1" fmla="*/ 0 w 397669"/>
              <a:gd name="connsiteY1" fmla="*/ 0 h 295275"/>
              <a:gd name="connsiteX2" fmla="*/ 397669 w 397669"/>
              <a:gd name="connsiteY2" fmla="*/ 0 h 295275"/>
              <a:gd name="connsiteX3" fmla="*/ 397669 w 397669"/>
              <a:gd name="connsiteY3" fmla="*/ 76200 h 295275"/>
              <a:gd name="connsiteX4" fmla="*/ 0 w 397669"/>
              <a:gd name="connsiteY4" fmla="*/ 295275 h 295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7669" h="295275">
                <a:moveTo>
                  <a:pt x="0" y="295275"/>
                </a:moveTo>
                <a:lnTo>
                  <a:pt x="0" y="0"/>
                </a:lnTo>
                <a:lnTo>
                  <a:pt x="397669" y="0"/>
                </a:lnTo>
                <a:lnTo>
                  <a:pt x="397669" y="76200"/>
                </a:lnTo>
                <a:lnTo>
                  <a:pt x="0" y="295275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283" name="フリーフォーム 282"/>
          <p:cNvSpPr/>
          <p:nvPr/>
        </p:nvSpPr>
        <p:spPr>
          <a:xfrm>
            <a:off x="4162792" y="1116087"/>
            <a:ext cx="769390" cy="621811"/>
          </a:xfrm>
          <a:custGeom>
            <a:avLst/>
            <a:gdLst>
              <a:gd name="connsiteX0" fmla="*/ 0 w 390525"/>
              <a:gd name="connsiteY0" fmla="*/ 319087 h 319087"/>
              <a:gd name="connsiteX1" fmla="*/ 0 w 390525"/>
              <a:gd name="connsiteY1" fmla="*/ 216694 h 319087"/>
              <a:gd name="connsiteX2" fmla="*/ 390525 w 390525"/>
              <a:gd name="connsiteY2" fmla="*/ 0 h 319087"/>
              <a:gd name="connsiteX3" fmla="*/ 390525 w 390525"/>
              <a:gd name="connsiteY3" fmla="*/ 316706 h 319087"/>
              <a:gd name="connsiteX4" fmla="*/ 0 w 390525"/>
              <a:gd name="connsiteY4" fmla="*/ 319087 h 3190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90525" h="319087">
                <a:moveTo>
                  <a:pt x="0" y="319087"/>
                </a:moveTo>
                <a:lnTo>
                  <a:pt x="0" y="216694"/>
                </a:lnTo>
                <a:lnTo>
                  <a:pt x="390525" y="0"/>
                </a:lnTo>
                <a:lnTo>
                  <a:pt x="390525" y="316706"/>
                </a:lnTo>
                <a:lnTo>
                  <a:pt x="0" y="31908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400"/>
          </a:p>
        </p:txBody>
      </p:sp>
      <p:sp>
        <p:nvSpPr>
          <p:cNvPr id="582" name="テキスト ボックス 581"/>
          <p:cNvSpPr txBox="1"/>
          <p:nvPr/>
        </p:nvSpPr>
        <p:spPr>
          <a:xfrm>
            <a:off x="4607110" y="1538074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0.7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09" name="テキスト ボックス 208"/>
          <p:cNvSpPr txBox="1"/>
          <p:nvPr/>
        </p:nvSpPr>
        <p:spPr>
          <a:xfrm>
            <a:off x="4103054" y="920552"/>
            <a:ext cx="631384" cy="260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99</a:t>
            </a:r>
            <a:r>
              <a:rPr kumimoji="1" lang="en-US" altLang="ja-JP" sz="800" dirty="0" smtClean="0">
                <a:latin typeface="+mn-ea"/>
              </a:rPr>
              <a:t>.3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268" name="テキスト ボックス 267"/>
          <p:cNvSpPr txBox="1"/>
          <p:nvPr/>
        </p:nvSpPr>
        <p:spPr>
          <a:xfrm>
            <a:off x="3131569" y="592450"/>
            <a:ext cx="819216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 smtClean="0">
                <a:latin typeface="+mn-ea"/>
              </a:rPr>
              <a:t>NOG-</a:t>
            </a:r>
          </a:p>
          <a:p>
            <a:pPr algn="ctr"/>
            <a:r>
              <a:rPr lang="en-US" altLang="ja-JP" sz="1000" b="1" dirty="0" smtClean="0">
                <a:latin typeface="+mn-ea"/>
              </a:rPr>
              <a:t>hIL-4-T</a:t>
            </a:r>
            <a:r>
              <a:rPr lang="ja-JP" altLang="en-US" sz="1000" b="1" dirty="0" err="1">
                <a:latin typeface="+mn-ea"/>
              </a:rPr>
              <a:t>ｇ</a:t>
            </a:r>
            <a:endParaRPr kumimoji="1" lang="en-US" altLang="ja-JP" sz="1000" b="1" dirty="0" smtClean="0">
              <a:latin typeface="+mn-ea"/>
            </a:endParaRPr>
          </a:p>
        </p:txBody>
      </p:sp>
      <p:sp>
        <p:nvSpPr>
          <p:cNvPr id="269" name="テキスト ボックス 268"/>
          <p:cNvSpPr txBox="1"/>
          <p:nvPr/>
        </p:nvSpPr>
        <p:spPr>
          <a:xfrm>
            <a:off x="2817891" y="288449"/>
            <a:ext cx="548395" cy="2308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b="1" dirty="0">
                <a:latin typeface="+mn-ea"/>
              </a:rPr>
              <a:t>Spleen</a:t>
            </a:r>
            <a:endParaRPr kumimoji="1" lang="ja-JP" altLang="en-US" sz="900" b="1" dirty="0">
              <a:latin typeface="+mn-ea"/>
            </a:endParaRPr>
          </a:p>
        </p:txBody>
      </p:sp>
      <p:sp>
        <p:nvSpPr>
          <p:cNvPr id="270" name="テキスト ボックス 269"/>
          <p:cNvSpPr txBox="1"/>
          <p:nvPr/>
        </p:nvSpPr>
        <p:spPr>
          <a:xfrm>
            <a:off x="4734438" y="288449"/>
            <a:ext cx="548395" cy="2308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b="1" dirty="0">
                <a:latin typeface="+mn-ea"/>
              </a:rPr>
              <a:t>BM</a:t>
            </a:r>
            <a:endParaRPr kumimoji="1" lang="ja-JP" altLang="en-US" sz="900" b="1" dirty="0">
              <a:latin typeface="+mn-ea"/>
            </a:endParaRPr>
          </a:p>
        </p:txBody>
      </p:sp>
      <p:sp>
        <p:nvSpPr>
          <p:cNvPr id="271" name="テキスト ボックス 270"/>
          <p:cNvSpPr txBox="1"/>
          <p:nvPr/>
        </p:nvSpPr>
        <p:spPr>
          <a:xfrm>
            <a:off x="5067350" y="592450"/>
            <a:ext cx="819216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 smtClean="0">
                <a:latin typeface="+mn-ea"/>
              </a:rPr>
              <a:t>NOG-</a:t>
            </a:r>
          </a:p>
          <a:p>
            <a:pPr algn="ctr"/>
            <a:r>
              <a:rPr lang="en-US" altLang="ja-JP" sz="1000" b="1" dirty="0" smtClean="0">
                <a:latin typeface="+mn-ea"/>
              </a:rPr>
              <a:t>hIL-4-T</a:t>
            </a:r>
            <a:r>
              <a:rPr lang="ja-JP" altLang="en-US" sz="1000" b="1" dirty="0" err="1">
                <a:latin typeface="+mn-ea"/>
              </a:rPr>
              <a:t>ｇ</a:t>
            </a:r>
            <a:endParaRPr kumimoji="1" lang="en-US" altLang="ja-JP" sz="1000" b="1" dirty="0" smtClean="0">
              <a:latin typeface="+mn-ea"/>
            </a:endParaRPr>
          </a:p>
        </p:txBody>
      </p:sp>
      <p:sp>
        <p:nvSpPr>
          <p:cNvPr id="272" name="テキスト ボックス 271"/>
          <p:cNvSpPr txBox="1"/>
          <p:nvPr/>
        </p:nvSpPr>
        <p:spPr>
          <a:xfrm>
            <a:off x="2358174" y="746339"/>
            <a:ext cx="462425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 smtClean="0">
                <a:latin typeface="+mn-ea"/>
              </a:rPr>
              <a:t>NOG</a:t>
            </a:r>
            <a:endParaRPr kumimoji="1" lang="en-US" altLang="ja-JP" sz="1000" b="1" dirty="0" smtClean="0">
              <a:latin typeface="+mn-ea"/>
            </a:endParaRPr>
          </a:p>
        </p:txBody>
      </p:sp>
      <p:sp>
        <p:nvSpPr>
          <p:cNvPr id="273" name="テキスト ボックス 272"/>
          <p:cNvSpPr txBox="1"/>
          <p:nvPr/>
        </p:nvSpPr>
        <p:spPr>
          <a:xfrm>
            <a:off x="4324057" y="746339"/>
            <a:ext cx="462425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 smtClean="0">
                <a:latin typeface="+mn-ea"/>
              </a:rPr>
              <a:t>NOG</a:t>
            </a:r>
            <a:endParaRPr kumimoji="1" lang="en-US" altLang="ja-JP" sz="1000" b="1" dirty="0" smtClean="0">
              <a:latin typeface="+mn-ea"/>
            </a:endParaRPr>
          </a:p>
        </p:txBody>
      </p:sp>
      <p:sp>
        <p:nvSpPr>
          <p:cNvPr id="274" name="テキスト ボックス 273"/>
          <p:cNvSpPr txBox="1"/>
          <p:nvPr/>
        </p:nvSpPr>
        <p:spPr>
          <a:xfrm>
            <a:off x="1463701" y="746339"/>
            <a:ext cx="462425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 smtClean="0">
                <a:latin typeface="+mn-ea"/>
              </a:rPr>
              <a:t>HD</a:t>
            </a:r>
          </a:p>
        </p:txBody>
      </p:sp>
      <p:cxnSp>
        <p:nvCxnSpPr>
          <p:cNvPr id="278" name="直線矢印コネクタ 277"/>
          <p:cNvCxnSpPr/>
          <p:nvPr/>
        </p:nvCxnSpPr>
        <p:spPr>
          <a:xfrm>
            <a:off x="865872" y="2559299"/>
            <a:ext cx="27710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9" name="直線矢印コネクタ 278"/>
          <p:cNvCxnSpPr/>
          <p:nvPr/>
        </p:nvCxnSpPr>
        <p:spPr>
          <a:xfrm flipV="1">
            <a:off x="865872" y="2282194"/>
            <a:ext cx="0" cy="27710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0" name="テキスト ボックス 279"/>
          <p:cNvSpPr txBox="1"/>
          <p:nvPr/>
        </p:nvSpPr>
        <p:spPr>
          <a:xfrm>
            <a:off x="847365" y="2536086"/>
            <a:ext cx="4385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8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281" name="テキスト ボックス 280"/>
          <p:cNvSpPr txBox="1"/>
          <p:nvPr/>
        </p:nvSpPr>
        <p:spPr>
          <a:xfrm rot="16200000">
            <a:off x="584847" y="2293285"/>
            <a:ext cx="4189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4</a:t>
            </a:r>
            <a:endParaRPr kumimoji="1" lang="ja-JP" altLang="en-US" sz="600" dirty="0">
              <a:latin typeface="+mn-ea"/>
            </a:endParaRPr>
          </a:p>
        </p:txBody>
      </p:sp>
      <p:cxnSp>
        <p:nvCxnSpPr>
          <p:cNvPr id="288" name="直線矢印コネクタ 287"/>
          <p:cNvCxnSpPr/>
          <p:nvPr/>
        </p:nvCxnSpPr>
        <p:spPr>
          <a:xfrm>
            <a:off x="865871" y="1695204"/>
            <a:ext cx="27710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9" name="直線矢印コネクタ 288"/>
          <p:cNvCxnSpPr/>
          <p:nvPr/>
        </p:nvCxnSpPr>
        <p:spPr>
          <a:xfrm flipV="1">
            <a:off x="865871" y="1418098"/>
            <a:ext cx="0" cy="27710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0" name="テキスト ボックス 289"/>
          <p:cNvSpPr txBox="1"/>
          <p:nvPr/>
        </p:nvSpPr>
        <p:spPr>
          <a:xfrm>
            <a:off x="847365" y="1671990"/>
            <a:ext cx="5307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45RA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293" name="テキスト ボックス 292"/>
          <p:cNvSpPr txBox="1"/>
          <p:nvPr/>
        </p:nvSpPr>
        <p:spPr>
          <a:xfrm rot="16200000">
            <a:off x="554782" y="1399124"/>
            <a:ext cx="47908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45RO</a:t>
            </a:r>
            <a:endParaRPr kumimoji="1" lang="ja-JP" altLang="en-US" sz="600" dirty="0">
              <a:latin typeface="+mn-ea"/>
            </a:endParaRPr>
          </a:p>
        </p:txBody>
      </p:sp>
      <p:cxnSp>
        <p:nvCxnSpPr>
          <p:cNvPr id="296" name="直線矢印コネクタ 295"/>
          <p:cNvCxnSpPr/>
          <p:nvPr/>
        </p:nvCxnSpPr>
        <p:spPr>
          <a:xfrm>
            <a:off x="865872" y="3463949"/>
            <a:ext cx="27710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7" name="直線矢印コネクタ 296"/>
          <p:cNvCxnSpPr/>
          <p:nvPr/>
        </p:nvCxnSpPr>
        <p:spPr>
          <a:xfrm flipV="1">
            <a:off x="865872" y="3186844"/>
            <a:ext cx="0" cy="27710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0" name="テキスト ボックス 299"/>
          <p:cNvSpPr txBox="1"/>
          <p:nvPr/>
        </p:nvSpPr>
        <p:spPr>
          <a:xfrm>
            <a:off x="866328" y="3440736"/>
            <a:ext cx="4385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8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305" name="テキスト ボックス 304"/>
          <p:cNvSpPr txBox="1"/>
          <p:nvPr/>
        </p:nvSpPr>
        <p:spPr>
          <a:xfrm rot="16200000">
            <a:off x="584847" y="3197935"/>
            <a:ext cx="4189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4</a:t>
            </a:r>
            <a:endParaRPr kumimoji="1" lang="ja-JP" altLang="en-US" sz="600" dirty="0">
              <a:latin typeface="+mn-ea"/>
            </a:endParaRPr>
          </a:p>
        </p:txBody>
      </p:sp>
      <p:cxnSp>
        <p:nvCxnSpPr>
          <p:cNvPr id="306" name="直線矢印コネクタ 305"/>
          <p:cNvCxnSpPr/>
          <p:nvPr/>
        </p:nvCxnSpPr>
        <p:spPr>
          <a:xfrm>
            <a:off x="865872" y="5264149"/>
            <a:ext cx="27710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7" name="直線矢印コネクタ 306"/>
          <p:cNvCxnSpPr/>
          <p:nvPr/>
        </p:nvCxnSpPr>
        <p:spPr>
          <a:xfrm flipV="1">
            <a:off x="865872" y="4987044"/>
            <a:ext cx="0" cy="27710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8" name="テキスト ボックス 307"/>
          <p:cNvSpPr txBox="1"/>
          <p:nvPr/>
        </p:nvSpPr>
        <p:spPr>
          <a:xfrm>
            <a:off x="847365" y="5240936"/>
            <a:ext cx="4385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38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309" name="テキスト ボックス 308"/>
          <p:cNvSpPr txBox="1"/>
          <p:nvPr/>
        </p:nvSpPr>
        <p:spPr>
          <a:xfrm rot="16200000">
            <a:off x="584847" y="4998135"/>
            <a:ext cx="4189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27</a:t>
            </a:r>
            <a:endParaRPr kumimoji="1" lang="ja-JP" altLang="en-US" sz="600" dirty="0">
              <a:latin typeface="+mn-ea"/>
            </a:endParaRPr>
          </a:p>
        </p:txBody>
      </p:sp>
      <p:cxnSp>
        <p:nvCxnSpPr>
          <p:cNvPr id="310" name="直線矢印コネクタ 309"/>
          <p:cNvCxnSpPr/>
          <p:nvPr/>
        </p:nvCxnSpPr>
        <p:spPr>
          <a:xfrm>
            <a:off x="865872" y="6159699"/>
            <a:ext cx="27710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1" name="直線矢印コネクタ 310"/>
          <p:cNvCxnSpPr/>
          <p:nvPr/>
        </p:nvCxnSpPr>
        <p:spPr>
          <a:xfrm flipV="1">
            <a:off x="865872" y="5882594"/>
            <a:ext cx="0" cy="27710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2" name="テキスト ボックス 311"/>
          <p:cNvSpPr txBox="1"/>
          <p:nvPr/>
        </p:nvSpPr>
        <p:spPr>
          <a:xfrm>
            <a:off x="866328" y="6136486"/>
            <a:ext cx="4385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19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313" name="テキスト ボックス 312"/>
          <p:cNvSpPr txBox="1"/>
          <p:nvPr/>
        </p:nvSpPr>
        <p:spPr>
          <a:xfrm rot="16200000">
            <a:off x="584847" y="5893685"/>
            <a:ext cx="4189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5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326" name="テキスト ボックス 325"/>
          <p:cNvSpPr txBox="1"/>
          <p:nvPr/>
        </p:nvSpPr>
        <p:spPr>
          <a:xfrm>
            <a:off x="4302390" y="1884000"/>
            <a:ext cx="6313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66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27" name="テキスト ボックス 326"/>
          <p:cNvSpPr txBox="1"/>
          <p:nvPr/>
        </p:nvSpPr>
        <p:spPr>
          <a:xfrm>
            <a:off x="4302390" y="2864768"/>
            <a:ext cx="6313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71.0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90" name="フリーフォーム 89"/>
          <p:cNvSpPr/>
          <p:nvPr/>
        </p:nvSpPr>
        <p:spPr>
          <a:xfrm>
            <a:off x="5159840" y="2197191"/>
            <a:ext cx="444043" cy="411151"/>
          </a:xfrm>
          <a:custGeom>
            <a:avLst/>
            <a:gdLst>
              <a:gd name="connsiteX0" fmla="*/ 65784 w 444043"/>
              <a:gd name="connsiteY0" fmla="*/ 411151 h 411151"/>
              <a:gd name="connsiteX1" fmla="*/ 0 w 444043"/>
              <a:gd name="connsiteY1" fmla="*/ 207221 h 411151"/>
              <a:gd name="connsiteX2" fmla="*/ 131568 w 444043"/>
              <a:gd name="connsiteY2" fmla="*/ 0 h 411151"/>
              <a:gd name="connsiteX3" fmla="*/ 444043 w 444043"/>
              <a:gd name="connsiteY3" fmla="*/ 0 h 411151"/>
              <a:gd name="connsiteX4" fmla="*/ 440754 w 444043"/>
              <a:gd name="connsiteY4" fmla="*/ 404573 h 411151"/>
              <a:gd name="connsiteX5" fmla="*/ 65784 w 444043"/>
              <a:gd name="connsiteY5" fmla="*/ 411151 h 41115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444043" h="411151">
                <a:moveTo>
                  <a:pt x="65784" y="411151"/>
                </a:moveTo>
                <a:lnTo>
                  <a:pt x="0" y="207221"/>
                </a:lnTo>
                <a:lnTo>
                  <a:pt x="131568" y="0"/>
                </a:lnTo>
                <a:lnTo>
                  <a:pt x="444043" y="0"/>
                </a:lnTo>
                <a:cubicBezTo>
                  <a:pt x="442947" y="134858"/>
                  <a:pt x="441850" y="269715"/>
                  <a:pt x="440754" y="404573"/>
                </a:cubicBezTo>
                <a:lnTo>
                  <a:pt x="65784" y="411151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1" name="フリーフォーム 90"/>
          <p:cNvSpPr/>
          <p:nvPr/>
        </p:nvSpPr>
        <p:spPr>
          <a:xfrm>
            <a:off x="5077610" y="1999839"/>
            <a:ext cx="210509" cy="404573"/>
          </a:xfrm>
          <a:custGeom>
            <a:avLst/>
            <a:gdLst>
              <a:gd name="connsiteX0" fmla="*/ 78941 w 210509"/>
              <a:gd name="connsiteY0" fmla="*/ 404573 h 404573"/>
              <a:gd name="connsiteX1" fmla="*/ 3289 w 210509"/>
              <a:gd name="connsiteY1" fmla="*/ 279583 h 404573"/>
              <a:gd name="connsiteX2" fmla="*/ 0 w 210509"/>
              <a:gd name="connsiteY2" fmla="*/ 55916 h 404573"/>
              <a:gd name="connsiteX3" fmla="*/ 95387 w 210509"/>
              <a:gd name="connsiteY3" fmla="*/ 0 h 404573"/>
              <a:gd name="connsiteX4" fmla="*/ 210509 w 210509"/>
              <a:gd name="connsiteY4" fmla="*/ 59206 h 404573"/>
              <a:gd name="connsiteX5" fmla="*/ 210509 w 210509"/>
              <a:gd name="connsiteY5" fmla="*/ 197352 h 404573"/>
              <a:gd name="connsiteX6" fmla="*/ 78941 w 210509"/>
              <a:gd name="connsiteY6" fmla="*/ 404573 h 40457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10509" h="404573">
                <a:moveTo>
                  <a:pt x="78941" y="404573"/>
                </a:moveTo>
                <a:lnTo>
                  <a:pt x="3289" y="279583"/>
                </a:lnTo>
                <a:cubicBezTo>
                  <a:pt x="2193" y="205027"/>
                  <a:pt x="1096" y="130472"/>
                  <a:pt x="0" y="55916"/>
                </a:cubicBezTo>
                <a:lnTo>
                  <a:pt x="95387" y="0"/>
                </a:lnTo>
                <a:lnTo>
                  <a:pt x="210509" y="59206"/>
                </a:lnTo>
                <a:lnTo>
                  <a:pt x="210509" y="197352"/>
                </a:lnTo>
                <a:lnTo>
                  <a:pt x="78941" y="404573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2" name="フリーフォーム 91"/>
          <p:cNvSpPr/>
          <p:nvPr/>
        </p:nvSpPr>
        <p:spPr>
          <a:xfrm>
            <a:off x="5143394" y="3134616"/>
            <a:ext cx="457200" cy="374970"/>
          </a:xfrm>
          <a:custGeom>
            <a:avLst/>
            <a:gdLst>
              <a:gd name="connsiteX0" fmla="*/ 69073 w 457200"/>
              <a:gd name="connsiteY0" fmla="*/ 365102 h 374970"/>
              <a:gd name="connsiteX1" fmla="*/ 0 w 457200"/>
              <a:gd name="connsiteY1" fmla="*/ 151303 h 374970"/>
              <a:gd name="connsiteX2" fmla="*/ 111833 w 457200"/>
              <a:gd name="connsiteY2" fmla="*/ 0 h 374970"/>
              <a:gd name="connsiteX3" fmla="*/ 457200 w 457200"/>
              <a:gd name="connsiteY3" fmla="*/ 6578 h 374970"/>
              <a:gd name="connsiteX4" fmla="*/ 453911 w 457200"/>
              <a:gd name="connsiteY4" fmla="*/ 374970 h 374970"/>
              <a:gd name="connsiteX5" fmla="*/ 69073 w 457200"/>
              <a:gd name="connsiteY5" fmla="*/ 365102 h 3749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457200" h="374970">
                <a:moveTo>
                  <a:pt x="69073" y="365102"/>
                </a:moveTo>
                <a:lnTo>
                  <a:pt x="0" y="151303"/>
                </a:lnTo>
                <a:lnTo>
                  <a:pt x="111833" y="0"/>
                </a:lnTo>
                <a:lnTo>
                  <a:pt x="457200" y="6578"/>
                </a:lnTo>
                <a:cubicBezTo>
                  <a:pt x="456104" y="129375"/>
                  <a:pt x="455007" y="252173"/>
                  <a:pt x="453911" y="374970"/>
                </a:cubicBezTo>
                <a:lnTo>
                  <a:pt x="69073" y="365102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3" name="フリーフォーム 92"/>
          <p:cNvSpPr/>
          <p:nvPr/>
        </p:nvSpPr>
        <p:spPr>
          <a:xfrm>
            <a:off x="5080899" y="2930685"/>
            <a:ext cx="174328" cy="351945"/>
          </a:xfrm>
          <a:custGeom>
            <a:avLst/>
            <a:gdLst>
              <a:gd name="connsiteX0" fmla="*/ 52627 w 174328"/>
              <a:gd name="connsiteY0" fmla="*/ 351945 h 351945"/>
              <a:gd name="connsiteX1" fmla="*/ 0 w 174328"/>
              <a:gd name="connsiteY1" fmla="*/ 240112 h 351945"/>
              <a:gd name="connsiteX2" fmla="*/ 0 w 174328"/>
              <a:gd name="connsiteY2" fmla="*/ 141436 h 351945"/>
              <a:gd name="connsiteX3" fmla="*/ 118412 w 174328"/>
              <a:gd name="connsiteY3" fmla="*/ 0 h 351945"/>
              <a:gd name="connsiteX4" fmla="*/ 167750 w 174328"/>
              <a:gd name="connsiteY4" fmla="*/ 128279 h 351945"/>
              <a:gd name="connsiteX5" fmla="*/ 174328 w 174328"/>
              <a:gd name="connsiteY5" fmla="*/ 203931 h 351945"/>
              <a:gd name="connsiteX6" fmla="*/ 52627 w 174328"/>
              <a:gd name="connsiteY6" fmla="*/ 351945 h 35194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174328" h="351945">
                <a:moveTo>
                  <a:pt x="52627" y="351945"/>
                </a:moveTo>
                <a:lnTo>
                  <a:pt x="0" y="240112"/>
                </a:lnTo>
                <a:lnTo>
                  <a:pt x="0" y="141436"/>
                </a:lnTo>
                <a:lnTo>
                  <a:pt x="118412" y="0"/>
                </a:lnTo>
                <a:lnTo>
                  <a:pt x="167750" y="128279"/>
                </a:lnTo>
                <a:lnTo>
                  <a:pt x="174328" y="203931"/>
                </a:lnTo>
                <a:lnTo>
                  <a:pt x="52627" y="351945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07" name="直線コネクタ 106"/>
          <p:cNvCxnSpPr>
            <a:stCxn id="548" idx="1"/>
          </p:cNvCxnSpPr>
          <p:nvPr/>
        </p:nvCxnSpPr>
        <p:spPr>
          <a:xfrm flipH="1">
            <a:off x="5842334" y="5831770"/>
            <a:ext cx="260256" cy="2469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3" name="テキスト ボックス 352"/>
          <p:cNvSpPr txBox="1"/>
          <p:nvPr/>
        </p:nvSpPr>
        <p:spPr>
          <a:xfrm>
            <a:off x="570552" y="1856656"/>
            <a:ext cx="779509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 smtClean="0"/>
              <a:t>CD45RO+</a:t>
            </a:r>
          </a:p>
          <a:p>
            <a:pPr algn="r"/>
            <a:r>
              <a:rPr lang="en-US" altLang="ja-JP" sz="1200" dirty="0" smtClean="0"/>
              <a:t>gate</a:t>
            </a:r>
            <a:endParaRPr kumimoji="1" lang="en-US" altLang="ja-JP" sz="1200" dirty="0" smtClean="0"/>
          </a:p>
        </p:txBody>
      </p:sp>
      <p:sp>
        <p:nvSpPr>
          <p:cNvPr id="354" name="テキスト ボックス 353"/>
          <p:cNvSpPr txBox="1"/>
          <p:nvPr/>
        </p:nvSpPr>
        <p:spPr>
          <a:xfrm>
            <a:off x="530157" y="970739"/>
            <a:ext cx="81990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D3+ </a:t>
            </a:r>
            <a:r>
              <a:rPr lang="en-US" altLang="ja-JP" sz="1200" dirty="0" smtClean="0"/>
              <a:t>gate</a:t>
            </a:r>
            <a:endParaRPr kumimoji="1" lang="en-US" altLang="ja-JP" sz="1200" dirty="0" smtClean="0"/>
          </a:p>
        </p:txBody>
      </p:sp>
      <p:sp>
        <p:nvSpPr>
          <p:cNvPr id="355" name="テキスト ボックス 354"/>
          <p:cNvSpPr txBox="1"/>
          <p:nvPr/>
        </p:nvSpPr>
        <p:spPr>
          <a:xfrm>
            <a:off x="581902" y="2731785"/>
            <a:ext cx="768159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 smtClean="0"/>
              <a:t>CD45RA+</a:t>
            </a:r>
          </a:p>
          <a:p>
            <a:pPr algn="r"/>
            <a:r>
              <a:rPr lang="en-US" altLang="ja-JP" sz="1200" dirty="0" smtClean="0"/>
              <a:t>gate</a:t>
            </a:r>
            <a:endParaRPr kumimoji="1" lang="en-US" altLang="ja-JP" sz="1200" dirty="0" smtClean="0"/>
          </a:p>
        </p:txBody>
      </p:sp>
      <p:sp>
        <p:nvSpPr>
          <p:cNvPr id="356" name="テキスト ボックス 355"/>
          <p:cNvSpPr txBox="1"/>
          <p:nvPr/>
        </p:nvSpPr>
        <p:spPr>
          <a:xfrm>
            <a:off x="451610" y="4563662"/>
            <a:ext cx="898451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D19+ </a:t>
            </a:r>
            <a:r>
              <a:rPr lang="en-US" altLang="ja-JP" sz="1200" dirty="0" smtClean="0"/>
              <a:t>gate</a:t>
            </a:r>
            <a:endParaRPr kumimoji="1" lang="en-US" altLang="ja-JP" sz="1200" dirty="0" smtClean="0"/>
          </a:p>
        </p:txBody>
      </p:sp>
      <p:sp>
        <p:nvSpPr>
          <p:cNvPr id="357" name="テキスト ボックス 356"/>
          <p:cNvSpPr txBox="1"/>
          <p:nvPr/>
        </p:nvSpPr>
        <p:spPr>
          <a:xfrm>
            <a:off x="482066" y="5457056"/>
            <a:ext cx="867995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D27-</a:t>
            </a:r>
          </a:p>
          <a:p>
            <a:r>
              <a:rPr lang="en-US" altLang="ja-JP" sz="1200" dirty="0" smtClean="0"/>
              <a:t>CD38-</a:t>
            </a:r>
            <a:r>
              <a:rPr kumimoji="1" lang="en-US" altLang="ja-JP" sz="1200" dirty="0" smtClean="0"/>
              <a:t> </a:t>
            </a:r>
            <a:r>
              <a:rPr lang="en-US" altLang="ja-JP" sz="1200" dirty="0" smtClean="0"/>
              <a:t>gate</a:t>
            </a:r>
            <a:endParaRPr kumimoji="1" lang="en-US" altLang="ja-JP" sz="1200" dirty="0" smtClean="0"/>
          </a:p>
        </p:txBody>
      </p:sp>
      <p:sp>
        <p:nvSpPr>
          <p:cNvPr id="118" name="テキスト ボックス 117"/>
          <p:cNvSpPr txBox="1"/>
          <p:nvPr/>
        </p:nvSpPr>
        <p:spPr>
          <a:xfrm rot="16200000">
            <a:off x="-25297" y="2086710"/>
            <a:ext cx="7731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 smtClean="0">
                <a:latin typeface="+mn-ea"/>
              </a:rPr>
              <a:t>T cell</a:t>
            </a:r>
            <a:endParaRPr kumimoji="1" lang="ja-JP" altLang="en-US" sz="900" b="1" dirty="0">
              <a:latin typeface="+mn-ea"/>
            </a:endParaRPr>
          </a:p>
        </p:txBody>
      </p:sp>
      <p:cxnSp>
        <p:nvCxnSpPr>
          <p:cNvPr id="120" name="直線コネクタ 119"/>
          <p:cNvCxnSpPr/>
          <p:nvPr/>
        </p:nvCxnSpPr>
        <p:spPr>
          <a:xfrm flipH="1">
            <a:off x="456691" y="957093"/>
            <a:ext cx="2600" cy="25759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4" name="テキスト ボックス 363"/>
          <p:cNvSpPr txBox="1"/>
          <p:nvPr/>
        </p:nvSpPr>
        <p:spPr>
          <a:xfrm rot="16200000">
            <a:off x="-25297" y="4785967"/>
            <a:ext cx="7731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b="1" dirty="0">
                <a:latin typeface="+mn-ea"/>
              </a:rPr>
              <a:t>B</a:t>
            </a:r>
            <a:r>
              <a:rPr kumimoji="1" lang="en-US" altLang="ja-JP" sz="900" b="1" dirty="0" smtClean="0">
                <a:latin typeface="+mn-ea"/>
              </a:rPr>
              <a:t> cell</a:t>
            </a:r>
            <a:endParaRPr kumimoji="1" lang="ja-JP" altLang="en-US" sz="900" b="1" dirty="0">
              <a:latin typeface="+mn-ea"/>
            </a:endParaRPr>
          </a:p>
        </p:txBody>
      </p:sp>
      <p:cxnSp>
        <p:nvCxnSpPr>
          <p:cNvPr id="365" name="直線コネクタ 364"/>
          <p:cNvCxnSpPr/>
          <p:nvPr/>
        </p:nvCxnSpPr>
        <p:spPr>
          <a:xfrm flipH="1">
            <a:off x="457103" y="3656856"/>
            <a:ext cx="1776" cy="25759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8" name="テキスト ボックス 367"/>
          <p:cNvSpPr txBox="1"/>
          <p:nvPr/>
        </p:nvSpPr>
        <p:spPr>
          <a:xfrm>
            <a:off x="6092434" y="992560"/>
            <a:ext cx="475474" cy="184666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+mn-ea"/>
              </a:rPr>
              <a:t>Memory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369" name="テキスト ボックス 368"/>
          <p:cNvSpPr txBox="1"/>
          <p:nvPr/>
        </p:nvSpPr>
        <p:spPr>
          <a:xfrm>
            <a:off x="6092434" y="1280592"/>
            <a:ext cx="392954" cy="184666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600" dirty="0" smtClean="0">
                <a:latin typeface="+mn-ea"/>
              </a:rPr>
              <a:t>Naive</a:t>
            </a:r>
            <a:endParaRPr kumimoji="1" lang="ja-JP" altLang="en-US" sz="600" dirty="0">
              <a:latin typeface="+mn-ea"/>
            </a:endParaRPr>
          </a:p>
        </p:txBody>
      </p:sp>
      <p:cxnSp>
        <p:nvCxnSpPr>
          <p:cNvPr id="370" name="直線コネクタ 369"/>
          <p:cNvCxnSpPr>
            <a:stCxn id="368" idx="1"/>
          </p:cNvCxnSpPr>
          <p:nvPr/>
        </p:nvCxnSpPr>
        <p:spPr>
          <a:xfrm flipH="1" flipV="1">
            <a:off x="5850206" y="1050896"/>
            <a:ext cx="242228" cy="33997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1" name="直線コネクタ 370"/>
          <p:cNvCxnSpPr>
            <a:stCxn id="369" idx="1"/>
          </p:cNvCxnSpPr>
          <p:nvPr/>
        </p:nvCxnSpPr>
        <p:spPr>
          <a:xfrm flipH="1">
            <a:off x="5850206" y="1372925"/>
            <a:ext cx="242228" cy="11853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77" name="Picture 3"/>
          <p:cNvPicPr>
            <a:picLocks noChangeAspect="1" noChangeArrowheads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32" t="9129" r="3709" b="19745"/>
          <a:stretch/>
        </p:blipFill>
        <p:spPr bwMode="auto">
          <a:xfrm>
            <a:off x="1257258" y="3616515"/>
            <a:ext cx="840544" cy="8245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78" name="Picture 9"/>
          <p:cNvPicPr>
            <a:picLocks noChangeAspect="1" noChangeArrowheads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32" t="9621" r="3709" b="20201"/>
          <a:stretch/>
        </p:blipFill>
        <p:spPr bwMode="auto">
          <a:xfrm>
            <a:off x="2214541" y="3622013"/>
            <a:ext cx="840544" cy="8135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79" name="Picture 4"/>
          <p:cNvPicPr>
            <a:picLocks noChangeAspect="1" noChangeArrowheads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32" t="9577" r="3709" b="20009"/>
          <a:stretch/>
        </p:blipFill>
        <p:spPr bwMode="auto">
          <a:xfrm>
            <a:off x="3107993" y="3635357"/>
            <a:ext cx="840544" cy="8163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80" name="Picture 9"/>
          <p:cNvPicPr>
            <a:picLocks noChangeAspect="1" noChangeArrowheads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97" t="9300" r="4535" b="19983"/>
          <a:stretch/>
        </p:blipFill>
        <p:spPr bwMode="auto">
          <a:xfrm>
            <a:off x="4131413" y="3622013"/>
            <a:ext cx="825011" cy="8198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81" name="Picture 4"/>
          <p:cNvPicPr>
            <a:picLocks noChangeAspect="1" noChangeArrowheads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97" t="9356" r="4535" b="20219"/>
          <a:stretch/>
        </p:blipFill>
        <p:spPr bwMode="auto">
          <a:xfrm>
            <a:off x="5040338" y="3625402"/>
            <a:ext cx="825011" cy="816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82" name="直線矢印コネクタ 381"/>
          <p:cNvCxnSpPr/>
          <p:nvPr/>
        </p:nvCxnSpPr>
        <p:spPr>
          <a:xfrm>
            <a:off x="856579" y="4359499"/>
            <a:ext cx="27710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3" name="直線矢印コネクタ 382"/>
          <p:cNvCxnSpPr/>
          <p:nvPr/>
        </p:nvCxnSpPr>
        <p:spPr>
          <a:xfrm flipV="1">
            <a:off x="856579" y="4082394"/>
            <a:ext cx="0" cy="27710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4" name="テキスト ボックス 383"/>
          <p:cNvSpPr txBox="1"/>
          <p:nvPr/>
        </p:nvSpPr>
        <p:spPr>
          <a:xfrm>
            <a:off x="857035" y="4336286"/>
            <a:ext cx="43858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19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385" name="テキスト ボックス 384"/>
          <p:cNvSpPr txBox="1"/>
          <p:nvPr/>
        </p:nvSpPr>
        <p:spPr>
          <a:xfrm rot="16200000">
            <a:off x="575554" y="4093485"/>
            <a:ext cx="4189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CD5</a:t>
            </a:r>
            <a:endParaRPr kumimoji="1" lang="ja-JP" altLang="en-US" sz="600" dirty="0">
              <a:latin typeface="+mn-ea"/>
            </a:endParaRPr>
          </a:p>
        </p:txBody>
      </p:sp>
      <p:sp>
        <p:nvSpPr>
          <p:cNvPr id="1033" name="フリーフォーム 1032"/>
          <p:cNvSpPr/>
          <p:nvPr/>
        </p:nvSpPr>
        <p:spPr>
          <a:xfrm>
            <a:off x="1667435" y="3686563"/>
            <a:ext cx="318592" cy="719935"/>
          </a:xfrm>
          <a:custGeom>
            <a:avLst/>
            <a:gdLst>
              <a:gd name="connsiteX0" fmla="*/ 0 w 318592"/>
              <a:gd name="connsiteY0" fmla="*/ 715797 h 719935"/>
              <a:gd name="connsiteX1" fmla="*/ 0 w 318592"/>
              <a:gd name="connsiteY1" fmla="*/ 306179 h 719935"/>
              <a:gd name="connsiteX2" fmla="*/ 153090 w 318592"/>
              <a:gd name="connsiteY2" fmla="*/ 186190 h 719935"/>
              <a:gd name="connsiteX3" fmla="*/ 318592 w 318592"/>
              <a:gd name="connsiteY3" fmla="*/ 0 h 719935"/>
              <a:gd name="connsiteX4" fmla="*/ 314455 w 318592"/>
              <a:gd name="connsiteY4" fmla="*/ 719935 h 719935"/>
              <a:gd name="connsiteX5" fmla="*/ 0 w 318592"/>
              <a:gd name="connsiteY5" fmla="*/ 715797 h 71993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318592" h="719935">
                <a:moveTo>
                  <a:pt x="0" y="715797"/>
                </a:moveTo>
                <a:lnTo>
                  <a:pt x="0" y="306179"/>
                </a:lnTo>
                <a:lnTo>
                  <a:pt x="153090" y="186190"/>
                </a:lnTo>
                <a:lnTo>
                  <a:pt x="318592" y="0"/>
                </a:lnTo>
                <a:lnTo>
                  <a:pt x="314455" y="719935"/>
                </a:lnTo>
                <a:lnTo>
                  <a:pt x="0" y="71579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7" name="テキスト ボックス 386"/>
          <p:cNvSpPr txBox="1"/>
          <p:nvPr/>
        </p:nvSpPr>
        <p:spPr>
          <a:xfrm>
            <a:off x="1340768" y="3972232"/>
            <a:ext cx="6313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8.66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034" name="フリーフォーム 1033"/>
          <p:cNvSpPr/>
          <p:nvPr/>
        </p:nvSpPr>
        <p:spPr>
          <a:xfrm>
            <a:off x="2449433" y="3690700"/>
            <a:ext cx="492370" cy="715798"/>
          </a:xfrm>
          <a:custGeom>
            <a:avLst/>
            <a:gdLst>
              <a:gd name="connsiteX0" fmla="*/ 4138 w 492370"/>
              <a:gd name="connsiteY0" fmla="*/ 715798 h 715798"/>
              <a:gd name="connsiteX1" fmla="*/ 0 w 492370"/>
              <a:gd name="connsiteY1" fmla="*/ 359968 h 715798"/>
              <a:gd name="connsiteX2" fmla="*/ 148953 w 492370"/>
              <a:gd name="connsiteY2" fmla="*/ 318592 h 715798"/>
              <a:gd name="connsiteX3" fmla="*/ 331005 w 492370"/>
              <a:gd name="connsiteY3" fmla="*/ 186190 h 715798"/>
              <a:gd name="connsiteX4" fmla="*/ 492370 w 492370"/>
              <a:gd name="connsiteY4" fmla="*/ 0 h 715798"/>
              <a:gd name="connsiteX5" fmla="*/ 488232 w 492370"/>
              <a:gd name="connsiteY5" fmla="*/ 711660 h 715798"/>
              <a:gd name="connsiteX6" fmla="*/ 4138 w 492370"/>
              <a:gd name="connsiteY6" fmla="*/ 715798 h 71579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92370" h="715798">
                <a:moveTo>
                  <a:pt x="4138" y="715798"/>
                </a:moveTo>
                <a:cubicBezTo>
                  <a:pt x="2759" y="597188"/>
                  <a:pt x="1379" y="478578"/>
                  <a:pt x="0" y="359968"/>
                </a:cubicBezTo>
                <a:lnTo>
                  <a:pt x="148953" y="318592"/>
                </a:lnTo>
                <a:lnTo>
                  <a:pt x="331005" y="186190"/>
                </a:lnTo>
                <a:lnTo>
                  <a:pt x="492370" y="0"/>
                </a:lnTo>
                <a:cubicBezTo>
                  <a:pt x="490991" y="237220"/>
                  <a:pt x="489611" y="474440"/>
                  <a:pt x="488232" y="711660"/>
                </a:cubicBezTo>
                <a:lnTo>
                  <a:pt x="4138" y="715798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9" name="テキスト ボックス 388"/>
          <p:cNvSpPr txBox="1"/>
          <p:nvPr/>
        </p:nvSpPr>
        <p:spPr>
          <a:xfrm>
            <a:off x="2149543" y="3970374"/>
            <a:ext cx="6313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.02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037" name="フリーフォーム 1036"/>
          <p:cNvSpPr/>
          <p:nvPr/>
        </p:nvSpPr>
        <p:spPr>
          <a:xfrm>
            <a:off x="3347283" y="3719663"/>
            <a:ext cx="488232" cy="703385"/>
          </a:xfrm>
          <a:custGeom>
            <a:avLst/>
            <a:gdLst>
              <a:gd name="connsiteX0" fmla="*/ 0 w 488232"/>
              <a:gd name="connsiteY0" fmla="*/ 699247 h 703385"/>
              <a:gd name="connsiteX1" fmla="*/ 4138 w 488232"/>
              <a:gd name="connsiteY1" fmla="*/ 347555 h 703385"/>
              <a:gd name="connsiteX2" fmla="*/ 182053 w 488232"/>
              <a:gd name="connsiteY2" fmla="*/ 314455 h 703385"/>
              <a:gd name="connsiteX3" fmla="*/ 372380 w 488232"/>
              <a:gd name="connsiteY3" fmla="*/ 202741 h 703385"/>
              <a:gd name="connsiteX4" fmla="*/ 488232 w 488232"/>
              <a:gd name="connsiteY4" fmla="*/ 0 h 703385"/>
              <a:gd name="connsiteX5" fmla="*/ 484094 w 488232"/>
              <a:gd name="connsiteY5" fmla="*/ 703385 h 703385"/>
              <a:gd name="connsiteX6" fmla="*/ 0 w 488232"/>
              <a:gd name="connsiteY6" fmla="*/ 699247 h 70338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88232" h="703385">
                <a:moveTo>
                  <a:pt x="0" y="699247"/>
                </a:moveTo>
                <a:cubicBezTo>
                  <a:pt x="1379" y="582016"/>
                  <a:pt x="2759" y="464786"/>
                  <a:pt x="4138" y="347555"/>
                </a:cubicBezTo>
                <a:lnTo>
                  <a:pt x="182053" y="314455"/>
                </a:lnTo>
                <a:lnTo>
                  <a:pt x="372380" y="202741"/>
                </a:lnTo>
                <a:lnTo>
                  <a:pt x="488232" y="0"/>
                </a:lnTo>
                <a:cubicBezTo>
                  <a:pt x="486853" y="234462"/>
                  <a:pt x="485473" y="468923"/>
                  <a:pt x="484094" y="703385"/>
                </a:cubicBezTo>
                <a:lnTo>
                  <a:pt x="0" y="699247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1" name="テキスト ボックス 390"/>
          <p:cNvSpPr txBox="1"/>
          <p:nvPr/>
        </p:nvSpPr>
        <p:spPr>
          <a:xfrm>
            <a:off x="3068960" y="3972232"/>
            <a:ext cx="6313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3.58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038" name="フリーフォーム 1037"/>
          <p:cNvSpPr/>
          <p:nvPr/>
        </p:nvSpPr>
        <p:spPr>
          <a:xfrm>
            <a:off x="4365122" y="3703113"/>
            <a:ext cx="488232" cy="707522"/>
          </a:xfrm>
          <a:custGeom>
            <a:avLst/>
            <a:gdLst>
              <a:gd name="connsiteX0" fmla="*/ 4138 w 488232"/>
              <a:gd name="connsiteY0" fmla="*/ 707522 h 707522"/>
              <a:gd name="connsiteX1" fmla="*/ 0 w 488232"/>
              <a:gd name="connsiteY1" fmla="*/ 347555 h 707522"/>
              <a:gd name="connsiteX2" fmla="*/ 136540 w 488232"/>
              <a:gd name="connsiteY2" fmla="*/ 314454 h 707522"/>
              <a:gd name="connsiteX3" fmla="*/ 322730 w 488232"/>
              <a:gd name="connsiteY3" fmla="*/ 173777 h 707522"/>
              <a:gd name="connsiteX4" fmla="*/ 488232 w 488232"/>
              <a:gd name="connsiteY4" fmla="*/ 0 h 707522"/>
              <a:gd name="connsiteX5" fmla="*/ 484094 w 488232"/>
              <a:gd name="connsiteY5" fmla="*/ 703385 h 707522"/>
              <a:gd name="connsiteX6" fmla="*/ 4138 w 488232"/>
              <a:gd name="connsiteY6" fmla="*/ 707522 h 7075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88232" h="707522">
                <a:moveTo>
                  <a:pt x="4138" y="707522"/>
                </a:moveTo>
                <a:cubicBezTo>
                  <a:pt x="2759" y="587533"/>
                  <a:pt x="1379" y="467544"/>
                  <a:pt x="0" y="347555"/>
                </a:cubicBezTo>
                <a:lnTo>
                  <a:pt x="136540" y="314454"/>
                </a:lnTo>
                <a:lnTo>
                  <a:pt x="322730" y="173777"/>
                </a:lnTo>
                <a:lnTo>
                  <a:pt x="488232" y="0"/>
                </a:lnTo>
                <a:cubicBezTo>
                  <a:pt x="486853" y="234462"/>
                  <a:pt x="485473" y="468923"/>
                  <a:pt x="484094" y="703385"/>
                </a:cubicBezTo>
                <a:lnTo>
                  <a:pt x="4138" y="707522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3" name="テキスト ボックス 392"/>
          <p:cNvSpPr txBox="1"/>
          <p:nvPr/>
        </p:nvSpPr>
        <p:spPr>
          <a:xfrm>
            <a:off x="4077072" y="3972232"/>
            <a:ext cx="6313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1.7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1039" name="フリーフォーム 1038"/>
          <p:cNvSpPr/>
          <p:nvPr/>
        </p:nvSpPr>
        <p:spPr>
          <a:xfrm>
            <a:off x="5275385" y="3703113"/>
            <a:ext cx="488231" cy="707522"/>
          </a:xfrm>
          <a:custGeom>
            <a:avLst/>
            <a:gdLst>
              <a:gd name="connsiteX0" fmla="*/ 0 w 488231"/>
              <a:gd name="connsiteY0" fmla="*/ 707522 h 707522"/>
              <a:gd name="connsiteX1" fmla="*/ 0 w 488231"/>
              <a:gd name="connsiteY1" fmla="*/ 355830 h 707522"/>
              <a:gd name="connsiteX2" fmla="*/ 140677 w 488231"/>
              <a:gd name="connsiteY2" fmla="*/ 306179 h 707522"/>
              <a:gd name="connsiteX3" fmla="*/ 310316 w 488231"/>
              <a:gd name="connsiteY3" fmla="*/ 177915 h 707522"/>
              <a:gd name="connsiteX4" fmla="*/ 488231 w 488231"/>
              <a:gd name="connsiteY4" fmla="*/ 0 h 707522"/>
              <a:gd name="connsiteX5" fmla="*/ 484094 w 488231"/>
              <a:gd name="connsiteY5" fmla="*/ 707522 h 707522"/>
              <a:gd name="connsiteX6" fmla="*/ 0 w 488231"/>
              <a:gd name="connsiteY6" fmla="*/ 707522 h 7075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88231" h="707522">
                <a:moveTo>
                  <a:pt x="0" y="707522"/>
                </a:moveTo>
                <a:lnTo>
                  <a:pt x="0" y="355830"/>
                </a:lnTo>
                <a:lnTo>
                  <a:pt x="140677" y="306179"/>
                </a:lnTo>
                <a:lnTo>
                  <a:pt x="310316" y="177915"/>
                </a:lnTo>
                <a:lnTo>
                  <a:pt x="488231" y="0"/>
                </a:lnTo>
                <a:lnTo>
                  <a:pt x="484094" y="707522"/>
                </a:lnTo>
                <a:lnTo>
                  <a:pt x="0" y="707522"/>
                </a:lnTo>
                <a:close/>
              </a:path>
            </a:pathLst>
          </a:cu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5" name="テキスト ボックス 394"/>
          <p:cNvSpPr txBox="1"/>
          <p:nvPr/>
        </p:nvSpPr>
        <p:spPr>
          <a:xfrm>
            <a:off x="5001096" y="3976665"/>
            <a:ext cx="6313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 smtClean="0">
                <a:latin typeface="+mn-ea"/>
              </a:rPr>
              <a:t>12.4</a:t>
            </a:r>
            <a:endParaRPr kumimoji="1" lang="ja-JP" altLang="en-US" sz="800" dirty="0">
              <a:latin typeface="+mn-ea"/>
            </a:endParaRPr>
          </a:p>
        </p:txBody>
      </p:sp>
      <p:sp>
        <p:nvSpPr>
          <p:cNvPr id="396" name="テキスト ボックス 395"/>
          <p:cNvSpPr txBox="1"/>
          <p:nvPr/>
        </p:nvSpPr>
        <p:spPr>
          <a:xfrm>
            <a:off x="6102590" y="4016896"/>
            <a:ext cx="609862" cy="184666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600" dirty="0" smtClean="0">
                <a:latin typeface="+mn-ea"/>
              </a:rPr>
              <a:t>B cell</a:t>
            </a:r>
          </a:p>
        </p:txBody>
      </p:sp>
      <p:cxnSp>
        <p:nvCxnSpPr>
          <p:cNvPr id="397" name="直線コネクタ 396"/>
          <p:cNvCxnSpPr>
            <a:stCxn id="396" idx="1"/>
          </p:cNvCxnSpPr>
          <p:nvPr/>
        </p:nvCxnSpPr>
        <p:spPr>
          <a:xfrm flipH="1">
            <a:off x="5763616" y="4109229"/>
            <a:ext cx="338974" cy="12065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9" name="テキスト ボックス 398"/>
          <p:cNvSpPr txBox="1"/>
          <p:nvPr/>
        </p:nvSpPr>
        <p:spPr>
          <a:xfrm>
            <a:off x="451610" y="3656856"/>
            <a:ext cx="898451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CD45+ </a:t>
            </a:r>
            <a:r>
              <a:rPr lang="en-US" altLang="ja-JP" sz="1200" dirty="0" smtClean="0"/>
              <a:t>gate</a:t>
            </a:r>
            <a:endParaRPr kumimoji="1" lang="en-US" altLang="ja-JP" sz="1200" dirty="0" smtClean="0"/>
          </a:p>
        </p:txBody>
      </p:sp>
      <p:sp>
        <p:nvSpPr>
          <p:cNvPr id="218" name="テキスト ボックス 217"/>
          <p:cNvSpPr txBox="1"/>
          <p:nvPr/>
        </p:nvSpPr>
        <p:spPr>
          <a:xfrm>
            <a:off x="1" y="-15552"/>
            <a:ext cx="10527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Fig. S </a:t>
            </a:r>
            <a:r>
              <a:rPr kumimoji="1" lang="en-US" altLang="ja-JP" dirty="0" smtClean="0"/>
              <a:t>2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4520896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91</TotalTime>
  <Words>139</Words>
  <Application>Microsoft Macintosh PowerPoint</Application>
  <PresentationFormat>A4 210x297 mm</PresentationFormat>
  <Paragraphs>10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 Ando</dc:creator>
  <cp:lastModifiedBy>Kametani Yoshie</cp:lastModifiedBy>
  <cp:revision>261</cp:revision>
  <cp:lastPrinted>2016-07-11T05:16:29Z</cp:lastPrinted>
  <dcterms:created xsi:type="dcterms:W3CDTF">2016-05-31T09:16:56Z</dcterms:created>
  <dcterms:modified xsi:type="dcterms:W3CDTF">2017-04-22T02:48:35Z</dcterms:modified>
</cp:coreProperties>
</file>